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56.png" ContentType="image/png"/>
  <Override PartName="/ppt/media/image29.png" ContentType="image/png"/>
  <Override PartName="/ppt/media/image50.png" ContentType="image/png"/>
  <Override PartName="/ppt/media/image5.jpeg" ContentType="image/jpeg"/>
  <Override PartName="/ppt/media/image14.png" ContentType="image/png"/>
  <Override PartName="/ppt/media/image2.png" ContentType="image/png"/>
  <Override PartName="/ppt/media/image32.png" ContentType="image/png"/>
  <Override PartName="/ppt/media/image25.png" ContentType="image/png"/>
  <Override PartName="/ppt/media/image33.png" ContentType="image/png"/>
  <Override PartName="/ppt/media/image3.png" ContentType="image/png"/>
  <Override PartName="/ppt/media/image15.png" ContentType="image/png"/>
  <Override PartName="/ppt/media/image26.png" ContentType="image/png"/>
  <Override PartName="/ppt/media/image47.png" ContentType="image/png"/>
  <Override PartName="/ppt/media/image1.jpeg" ContentType="image/jpeg"/>
  <Override PartName="/ppt/media/image21.png" ContentType="image/png"/>
  <Override PartName="/ppt/media/image58.png" ContentType="image/png"/>
  <Override PartName="/ppt/media/image28.png" ContentType="image/png"/>
  <Override PartName="/ppt/media/image16.png" ContentType="image/png"/>
  <Override PartName="/ppt/media/image27.png" ContentType="image/png"/>
  <Override PartName="/ppt/media/image24.png" ContentType="image/png"/>
  <Override PartName="/ppt/media/image59.wmf" ContentType="image/x-wmf"/>
  <Override PartName="/ppt/media/image60.png" ContentType="image/png"/>
  <Override PartName="/ppt/media/image23.png" ContentType="image/png"/>
  <Override PartName="/ppt/media/image20.png" ContentType="image/png"/>
  <Override PartName="/ppt/media/image10.png" ContentType="image/png"/>
  <Override PartName="/ppt/media/image36.jpeg" ContentType="image/jpeg"/>
  <Override PartName="/ppt/media/image57.png" ContentType="image/png"/>
  <Override PartName="/ppt/media/image40.png" ContentType="image/png"/>
  <Override PartName="/ppt/media/image22.png" ContentType="image/png"/>
  <Override PartName="/ppt/media/image17.png" ContentType="image/png"/>
  <Override PartName="/ppt/media/image18.png" ContentType="image/png"/>
  <Override PartName="/ppt/media/image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4.jpeg" ContentType="image/jpe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31.png" ContentType="image/png"/>
  <Override PartName="/ppt/media/image35.png" ContentType="image/png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4.jpeg" ContentType="image/jpeg"/>
  <Override PartName="/ppt/media/image51.png" ContentType="image/png"/>
  <Override PartName="/ppt/media/image52.png" ContentType="image/png"/>
  <Override PartName="/ppt/media/image53.png" ContentType="image/png"/>
  <Override PartName="/ppt/media/image54.png" ContentType="image/png"/>
  <Override PartName="/ppt/media/image55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40.xml" ContentType="application/vnd.openxmlformats-officedocument.presentationml.slide+xml"/>
  <Override PartName="/ppt/slides/slide6.xml" ContentType="application/vnd.openxmlformats-officedocument.presentationml.slide+xml"/>
  <Override PartName="/ppt/slides/slide41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39.xml" ContentType="application/vnd.openxmlformats-officedocument.presentationml.slide+xml"/>
  <Override PartName="/ppt/slides/slide50.xml" ContentType="application/vnd.openxmlformats-officedocument.presentationml.slide+xml"/>
  <Override PartName="/ppt/slides/slide13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34.xml" ContentType="application/vnd.openxmlformats-officedocument.presentationml.slide+xml"/>
  <Override PartName="/ppt/slides/slide33.xml" ContentType="application/vnd.openxmlformats-officedocument.presentationml.slide+xml"/>
  <Override PartName="/ppt/slides/slide32.xml" ContentType="application/vnd.openxmlformats-officedocument.presentationml.slide+xml"/>
  <Override PartName="/ppt/slides/slide31.xml" ContentType="application/vnd.openxmlformats-officedocument.presentationml.slide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_rels/slide47.xml.rels" ContentType="application/vnd.openxmlformats-package.relationships+xml"/>
  <Override PartName="/ppt/slides/_rels/slide54.xml.rels" ContentType="application/vnd.openxmlformats-package.relationships+xml"/>
  <Override PartName="/ppt/slides/_rels/slide4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36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27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26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8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34.xml.rels" ContentType="application/vnd.openxmlformats-package.relationships+xml"/>
  <Override PartName="/ppt/slides/_rels/slide50.xml.rels" ContentType="application/vnd.openxmlformats-package.relationships+xml"/>
  <Override PartName="/ppt/slides/_rels/slide49.xml.rels" ContentType="application/vnd.openxmlformats-package.relationships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52.xml.rels" ContentType="application/vnd.openxmlformats-package.relationships+xml"/>
  <Override PartName="/ppt/slides/_rels/slide45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38.xml.rels" ContentType="application/vnd.openxmlformats-package.relationships+xml"/>
  <Override PartName="/ppt/slides/_rels/slide23.xml.rels" ContentType="application/vnd.openxmlformats-package.relationships+xml"/>
  <Override PartName="/ppt/slides/_rels/slide46.xml.rels" ContentType="application/vnd.openxmlformats-package.relationships+xml"/>
  <Override PartName="/ppt/slides/_rels/slide53.xml.rels" ContentType="application/vnd.openxmlformats-package.relationships+xml"/>
  <Override PartName="/ppt/slides/_rels/slide1.xml.rels" ContentType="application/vnd.openxmlformats-package.relationships+xml"/>
  <Override PartName="/ppt/slides/_rels/slide7.xml.rels" ContentType="application/vnd.openxmlformats-package.relationships+xml"/>
  <Override PartName="/ppt/slides/_rels/slide20.xml.rels" ContentType="application/vnd.openxmlformats-package.relationships+xml"/>
  <Override PartName="/ppt/slides/_rels/slide51.xml.rels" ContentType="application/vnd.openxmlformats-package.relationships+xml"/>
  <Override PartName="/ppt/slides/_rels/slide35.xml.rels" ContentType="application/vnd.openxmlformats-package.relationships+xml"/>
  <Override PartName="/ppt/slides/_rels/slide42.xml.rels" ContentType="application/vnd.openxmlformats-package.relationships+xml"/>
  <Override PartName="/ppt/slides/_rels/slide40.xml.rels" ContentType="application/vnd.openxmlformats-package.relationships+xml"/>
  <Override PartName="/ppt/slides/_rels/slide55.xml.rels" ContentType="application/vnd.openxmlformats-package.relationships+xml"/>
  <Override PartName="/ppt/slides/_rels/slide5.xml.rels" ContentType="application/vnd.openxmlformats-package.relationships+xml"/>
  <Override PartName="/ppt/slides/_rels/slide33.xml.rels" ContentType="application/vnd.openxmlformats-package.relationships+xml"/>
  <Override PartName="/ppt/slides/_rels/slide48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slide30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  <p:sldId id="298" r:id="rId46"/>
    <p:sldId id="299" r:id="rId47"/>
    <p:sldId id="300" r:id="rId48"/>
    <p:sldId id="301" r:id="rId49"/>
    <p:sldId id="302" r:id="rId50"/>
    <p:sldId id="303" r:id="rId51"/>
    <p:sldId id="304" r:id="rId52"/>
    <p:sldId id="305" r:id="rId53"/>
    <p:sldId id="306" r:id="rId54"/>
    <p:sldId id="307" r:id="rId55"/>
    <p:sldId id="308" r:id="rId56"/>
    <p:sldId id="309" r:id="rId57"/>
    <p:sldId id="310" r:id="rId5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slide" Target="slides/slide39.xml"/><Relationship Id="rId43" Type="http://schemas.openxmlformats.org/officeDocument/2006/relationships/slide" Target="slides/slide40.xml"/><Relationship Id="rId44" Type="http://schemas.openxmlformats.org/officeDocument/2006/relationships/slide" Target="slides/slide41.xml"/><Relationship Id="rId45" Type="http://schemas.openxmlformats.org/officeDocument/2006/relationships/slide" Target="slides/slide42.xml"/><Relationship Id="rId46" Type="http://schemas.openxmlformats.org/officeDocument/2006/relationships/slide" Target="slides/slide43.xml"/><Relationship Id="rId47" Type="http://schemas.openxmlformats.org/officeDocument/2006/relationships/slide" Target="slides/slide44.xml"/><Relationship Id="rId48" Type="http://schemas.openxmlformats.org/officeDocument/2006/relationships/slide" Target="slides/slide45.xml"/><Relationship Id="rId49" Type="http://schemas.openxmlformats.org/officeDocument/2006/relationships/slide" Target="slides/slide46.xml"/><Relationship Id="rId50" Type="http://schemas.openxmlformats.org/officeDocument/2006/relationships/slide" Target="slides/slide47.xml"/><Relationship Id="rId51" Type="http://schemas.openxmlformats.org/officeDocument/2006/relationships/slide" Target="slides/slide48.xml"/><Relationship Id="rId52" Type="http://schemas.openxmlformats.org/officeDocument/2006/relationships/slide" Target="slides/slide49.xml"/><Relationship Id="rId53" Type="http://schemas.openxmlformats.org/officeDocument/2006/relationships/slide" Target="slides/slide50.xml"/><Relationship Id="rId54" Type="http://schemas.openxmlformats.org/officeDocument/2006/relationships/slide" Target="slides/slide51.xml"/><Relationship Id="rId55" Type="http://schemas.openxmlformats.org/officeDocument/2006/relationships/slide" Target="slides/slide52.xml"/><Relationship Id="rId56" Type="http://schemas.openxmlformats.org/officeDocument/2006/relationships/slide" Target="slides/slide53.xml"/><Relationship Id="rId57" Type="http://schemas.openxmlformats.org/officeDocument/2006/relationships/slide" Target="slides/slide54.xml"/><Relationship Id="rId58" Type="http://schemas.openxmlformats.org/officeDocument/2006/relationships/slide" Target="slides/slide55.xml"/><Relationship Id="rId5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CB966-DAE0-4471-B873-B579A34389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B0CC3-27E7-4DC4-B0DA-4C9115F603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BE2C8-703C-448B-8DB1-315DE5B6BC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3316E-D44E-4BBC-A876-6E56D9785D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9F98226-7839-430D-9763-56AA7F689E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E1D4AA6-3FE8-4640-A3C6-6087717469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93F5A93-EA62-4084-9CD2-D2D7D7A3B9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46C797E-03F2-4DFD-8811-3010ADC412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2C2A775-D993-426A-8FFF-1DAABB54C2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380880"/>
            <a:ext cx="82296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56D8773-3D12-4AC9-8914-DABD64B6FD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D5E075-FD8F-4167-9771-98F65CE64D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2787D-1B38-4755-B608-FBCFD6D6E2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F8E3AC1-12E0-496D-AAE9-125A21C45D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F8DD6BC-8AAE-407D-9641-38251532D6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BCACE83-3BA0-4FB9-B913-973AC6B600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5ACCFB-7D88-4AC9-B156-F04E27CD5C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0E8064A-6B31-460B-95B3-C05ECE2103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52975-93F2-4C36-8938-F7C37C6E2A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F8FFC-516A-4616-A7A5-83960E99BC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B9915-4429-4E9D-95D5-458BD3EF1A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380880"/>
            <a:ext cx="82296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6C460-5566-47BA-B075-F93899F566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CA4B3-53C4-43D2-A7DF-8C636F46B3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FCA3D-CFEC-4421-93C3-DAB13414B1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6D540-585C-4CFC-8D3C-7CCD037658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 algn="r" rtl="1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735480" indent="-282960" algn="r" rtl="1">
              <a:spcBef>
                <a:spcPts val="7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2" marL="1131480" indent="-226080" algn="r" rtl="1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3" marL="1584000" indent="-226080" algn="r" rtl="1">
              <a:spcBef>
                <a:spcPts val="7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4" marL="2036520" indent="-226080" algn="r" rtl="1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5" marL="2036520" indent="-226080" algn="r" rtl="1">
              <a:spcBef>
                <a:spcPts val="7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6" marL="2036520" indent="-226080" algn="r" rtl="1">
              <a:spcBef>
                <a:spcPts val="7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ar-SA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ar-SA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ar-SA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00DC75-5327-4ECE-9189-1C231668A725}" type="slidenum">
              <a:rPr b="0" lang="ar-SA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ar-SA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ar-SA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ar-SA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95A0EE-4381-4187-A8A3-7020B4D6312E}" type="slidenum">
              <a:rPr b="0" lang="ar-SA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457200" indent="0" algn="ctr" rtl="1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lvl="2" marL="914400" algn="ctr" rtl="1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lvl="3" marL="1371600" algn="ctr" rtl="1">
              <a:spcBef>
                <a:spcPts val="4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4" marL="1828800" algn="ctr" rtl="1"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mailto:mnkamelboulos@plymouth.ac.uk" TargetMode="External"/><Relationship Id="rId3" Type="http://schemas.openxmlformats.org/officeDocument/2006/relationships/hyperlink" Target="mailto:mnkamelboulos@plymouth.ac.uk" TargetMode="External"/><Relationship Id="rId4" Type="http://schemas.openxmlformats.org/officeDocument/2006/relationships/hyperlink" Target="mailto:mnkamelboulos@plymouth.ac.uk" TargetMode="External"/><Relationship Id="rId5" Type="http://schemas.openxmlformats.org/officeDocument/2006/relationships/hyperlink" Target="mailto:mnkamelboulos@plymouth.ac.uk" TargetMode="External"/><Relationship Id="rId6" Type="http://schemas.openxmlformats.org/officeDocument/2006/relationships/hyperlink" Target="mailto:mnkamelboulos@plymouth.ac.uk" TargetMode="External"/><Relationship Id="rId7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3.pn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www.educause.edu/ir/library/pdf/ELI7004.pdf" TargetMode="External"/><Relationship Id="rId3" Type="http://schemas.openxmlformats.org/officeDocument/2006/relationships/hyperlink" Target="http://siepr.stanford.edu/programs/OpenSoftware_David/oswp2.pdf" TargetMode="External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www.answers.com/topic/blog" TargetMode="External"/><Relationship Id="rId3" Type="http://schemas.openxmlformats.org/officeDocument/2006/relationships/hyperlink" Target="http://www.answers.com/topic/blog" TargetMode="External"/><Relationship Id="rId4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0.png"/><Relationship Id="rId3" Type="http://schemas.openxmlformats.org/officeDocument/2006/relationships/hyperlink" Target="http://casesblog.blogspot.com/" TargetMode="External"/><Relationship Id="rId4" Type="http://schemas.openxmlformats.org/officeDocument/2006/relationships/hyperlink" Target="http://clinicalcases.blogspot.com/" TargetMode="External"/><Relationship Id="rId5" Type="http://schemas.openxmlformats.org/officeDocument/2006/relationships/hyperlink" Target="http://clinicalcases.blogspot.com/" TargetMode="External"/><Relationship Id="rId6" Type="http://schemas.openxmlformats.org/officeDocument/2006/relationships/hyperlink" Target="http://clinicalcases.blogspot.com/" TargetMode="External"/><Relationship Id="rId7" Type="http://schemas.openxmlformats.org/officeDocument/2006/relationships/hyperlink" Target="http://clinicalcases.blogspot.com/" TargetMode="External"/><Relationship Id="rId8" Type="http://schemas.openxmlformats.org/officeDocument/2006/relationships/hyperlink" Target="http://clinicalcases.blogspot.com/" TargetMode="External"/><Relationship Id="rId9" Type="http://schemas.openxmlformats.org/officeDocument/2006/relationships/hyperlink" Target="http://clinicalcases.blogspot.com/" TargetMode="External"/><Relationship Id="rId10" Type="http://schemas.openxmlformats.org/officeDocument/2006/relationships/hyperlink" Target="http://clinicalcases.blogspot.com/" TargetMode="External"/><Relationship Id="rId11" Type="http://schemas.openxmlformats.org/officeDocument/2006/relationships/hyperlink" Target="http://clinicalcases.blogspot.com/" TargetMode="External"/><Relationship Id="rId1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1.png"/><Relationship Id="rId3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2.png"/><Relationship Id="rId3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5.png"/><Relationship Id="rId3" Type="http://schemas.openxmlformats.org/officeDocument/2006/relationships/hyperlink" Target="http://digutmb.blogspot.com/" TargetMode="External"/><Relationship Id="rId4" Type="http://schemas.openxmlformats.org/officeDocument/2006/relationships/hyperlink" Target="http://digutmb.blogspot.com/" TargetMode="External"/><Relationship Id="rId5" Type="http://schemas.openxmlformats.org/officeDocument/2006/relationships/hyperlink" Target="http://digutmb.blogspot.com/" TargetMode="External"/><Relationship Id="rId6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8.png"/><Relationship Id="rId3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9.png"/><Relationship Id="rId3" Type="http://schemas.openxmlformats.org/officeDocument/2006/relationships/hyperlink" Target="http://picasa.google.com/" TargetMode="External"/><Relationship Id="rId4" Type="http://schemas.openxmlformats.org/officeDocument/2006/relationships/hyperlink" Target="http://picasa.google.com/" TargetMode="External"/><Relationship Id="rId5" Type="http://schemas.openxmlformats.org/officeDocument/2006/relationships/hyperlink" Target="http://picasa.google.com/" TargetMode="External"/><Relationship Id="rId6" Type="http://schemas.openxmlformats.org/officeDocument/2006/relationships/hyperlink" Target="http://picasa.google.com/" TargetMode="External"/><Relationship Id="rId7" Type="http://schemas.openxmlformats.org/officeDocument/2006/relationships/hyperlink" Target="http://picasa.google.com/" TargetMode="External"/><Relationship Id="rId8" Type="http://schemas.openxmlformats.org/officeDocument/2006/relationships/hyperlink" Target="http://picasa.google.com/" TargetMode="External"/><Relationship Id="rId9" Type="http://schemas.openxmlformats.org/officeDocument/2006/relationships/hyperlink" Target="http://picasa.google.com/" TargetMode="External"/><Relationship Id="rId10" Type="http://schemas.openxmlformats.org/officeDocument/2006/relationships/hyperlink" Target="http://picasa.google.com/" TargetMode="External"/><Relationship Id="rId11" Type="http://schemas.openxmlformats.org/officeDocument/2006/relationships/image" Target="../media/image30.png"/><Relationship Id="rId1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1.png"/><Relationship Id="rId3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www.educause.edu/ir/library/pdf/ELI7006.pdf" TargetMode="External"/><Relationship Id="rId3" Type="http://schemas.openxmlformats.org/officeDocument/2006/relationships/image" Target="../media/image19.png"/><Relationship Id="rId4" Type="http://schemas.openxmlformats.org/officeDocument/2006/relationships/image" Target="../media/image33.png"/><Relationship Id="rId5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en.wikipedia.org/wiki/Podcast" TargetMode="External"/><Relationship Id="rId3" Type="http://schemas.openxmlformats.org/officeDocument/2006/relationships/hyperlink" Target="http://en.wikipedia.org/wiki/Podcast" TargetMode="External"/><Relationship Id="rId4" Type="http://schemas.openxmlformats.org/officeDocument/2006/relationships/image" Target="../media/image34.jpeg"/><Relationship Id="rId5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5.png"/><Relationship Id="rId3" Type="http://schemas.openxmlformats.org/officeDocument/2006/relationships/hyperlink" Target="http://edmarketing.apple.com/adcinstitute/wp-content/Missouri_Podcasting_White_Paper.pdf" TargetMode="External"/><Relationship Id="rId4" Type="http://schemas.openxmlformats.org/officeDocument/2006/relationships/image" Target="../media/image36.jpeg"/><Relationship Id="rId5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7.png"/><Relationship Id="rId3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8.png"/><Relationship Id="rId3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9.png"/><Relationship Id="rId3" Type="http://schemas.openxmlformats.org/officeDocument/2006/relationships/image" Target="../media/image40.png"/><Relationship Id="rId4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1.png"/><Relationship Id="rId3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2.png"/><Relationship Id="rId3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3.png"/><Relationship Id="rId3" Type="http://schemas.openxmlformats.org/officeDocument/2006/relationships/hyperlink" Target="http://www.cvmd.org/mission.php" TargetMode="External"/><Relationship Id="rId4" Type="http://schemas.openxmlformats.org/officeDocument/2006/relationships/hyperlink" Target="http://www.clevelandclinic.org/healthedge/" TargetMode="External"/><Relationship Id="rId5" Type="http://schemas.openxmlformats.org/officeDocument/2006/relationships/hyperlink" Target="http://www.clevelandclinic.org/healthedge/" TargetMode="External"/><Relationship Id="rId6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hyperlink" Target="http://webweekly.hms.harvard.edu/archive/2006/0130/student_scene.html" TargetMode="External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6.png"/><Relationship Id="rId3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www.educause.edu/ir/library/pdf/ELI7003.pdf" TargetMode="External"/><Relationship Id="rId3" Type="http://schemas.openxmlformats.org/officeDocument/2006/relationships/hyperlink" Target="http://denison.uchsc.edu/newsletter/issues/updateFEB06.html#Introduction" TargetMode="External"/><Relationship Id="rId4" Type="http://schemas.openxmlformats.org/officeDocument/2006/relationships/hyperlink" Target="http://www.carleton.ca/cutv/vod/vodcast.htm" TargetMode="External"/><Relationship Id="rId5" Type="http://schemas.openxmlformats.org/officeDocument/2006/relationships/hyperlink" Target="http://www.carleton.ca/cutv/vod/vodcast.htm" TargetMode="External"/><Relationship Id="rId6" Type="http://schemas.openxmlformats.org/officeDocument/2006/relationships/image" Target="../media/image19.png"/><Relationship Id="rId7" Type="http://schemas.openxmlformats.org/officeDocument/2006/relationships/image" Target="../media/image47.png"/><Relationship Id="rId8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8.png"/><Relationship Id="rId3" Type="http://schemas.openxmlformats.org/officeDocument/2006/relationships/image" Target="../media/image49.png"/><Relationship Id="rId4" Type="http://schemas.openxmlformats.org/officeDocument/2006/relationships/image" Target="../media/image50.png"/><Relationship Id="rId5" Type="http://schemas.openxmlformats.org/officeDocument/2006/relationships/slideLayout" Target="../slideLayouts/slideLayout8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1.png"/><Relationship Id="rId3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2.png"/><Relationship Id="rId3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3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4.png"/><Relationship Id="rId3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5.png"/><Relationship Id="rId3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6.png"/><Relationship Id="rId3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7.png"/><Relationship Id="rId3" Type="http://schemas.openxmlformats.org/officeDocument/2006/relationships/image" Target="../media/image58.png"/><Relationship Id="rId4" Type="http://schemas.openxmlformats.org/officeDocument/2006/relationships/image" Target="../media/image59.wmf"/><Relationship Id="rId5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0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http://wikipedia.org/" TargetMode="External"/><Relationship Id="rId3" Type="http://schemas.openxmlformats.org/officeDocument/2006/relationships/hyperlink" Target="http://wikipedia.org/" TargetMode="External"/><Relationship Id="rId4" Type="http://schemas.openxmlformats.org/officeDocument/2006/relationships/hyperlink" Target="http://wikipedia.org/" TargetMode="External"/><Relationship Id="rId5" Type="http://schemas.openxmlformats.org/officeDocument/2006/relationships/hyperlink" Target="http://wikimania.wikimedia.org/wiki/Main_Page" TargetMode="External"/><Relationship Id="rId6" Type="http://schemas.openxmlformats.org/officeDocument/2006/relationships/hyperlink" Target="http://www.wikisym.org/" TargetMode="External"/><Relationship Id="rId7" Type="http://schemas.openxmlformats.org/officeDocument/2006/relationships/hyperlink" Target="http://www.wikisym.org/ws2006" TargetMode="External"/><Relationship Id="rId8" Type="http://schemas.openxmlformats.org/officeDocument/2006/relationships/hyperlink" Target="http://www.answers.com/topic/wiki" TargetMode="External"/><Relationship Id="rId9" Type="http://schemas.openxmlformats.org/officeDocument/2006/relationships/hyperlink" Target="http://news.bbc.co.uk/2/hi/uk_news/magazine/4152860.stm" TargetMode="External"/><Relationship Id="rId10" Type="http://schemas.openxmlformats.org/officeDocument/2006/relationships/image" Target="../media/image6.png"/><Relationship Id="rId1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685800" y="1197000"/>
            <a:ext cx="7772400" cy="230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Wikis, Blogs and Podcasts: Emerging Tools for Virtual Collaborative Practice and Learning/CPD in Medicine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Maged N Kamel Boulos, PhD, FRGS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Senior Lecturer in Health Informatics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University of Plymouth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indent="0" algn="ctr">
              <a:lnSpc>
                <a:spcPct val="8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mnkamelboulos@plymouth</a:t>
            </a:r>
            <a:r>
              <a:rPr b="0" lang="en-GB" sz="28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.</a:t>
            </a:r>
            <a:r>
              <a:rPr b="0" lang="en-US" sz="28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ac</a:t>
            </a:r>
            <a:r>
              <a:rPr b="0" lang="en-GB" sz="28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.</a:t>
            </a:r>
            <a:r>
              <a:rPr b="0" lang="en-US" sz="2800" spc="-1" strike="noStrike" u="sng">
                <a:solidFill>
                  <a:srgbClr val="00ccff"/>
                </a:solidFill>
                <a:uFillTx/>
                <a:latin typeface="Tahoma"/>
                <a:hlinkClick r:id="rId6"/>
              </a:rPr>
              <a:t>uk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4" name=""/>
          <p:cNvSpPr/>
          <p:nvPr/>
        </p:nvSpPr>
        <p:spPr>
          <a:xfrm>
            <a:off x="977760" y="5959440"/>
            <a:ext cx="7201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“</a:t>
            </a: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The lecturer should give the audience full reason to believe that all his powers have been exerted for their pleasure and instruction.”</a:t>
            </a:r>
            <a:br>
              <a:rPr sz="1600"/>
            </a:b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—Michael Faraday (1791-1867) - English physicist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08" name=""/>
          <p:cNvSpPr/>
          <p:nvPr/>
        </p:nvSpPr>
        <p:spPr>
          <a:xfrm>
            <a:off x="5416920" y="100080"/>
            <a:ext cx="37699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Wiki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7522560" y="765000"/>
            <a:ext cx="1579680" cy="36828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Rosacea Wiki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11" name=""/>
          <p:cNvSpPr/>
          <p:nvPr/>
        </p:nvSpPr>
        <p:spPr>
          <a:xfrm>
            <a:off x="5416920" y="279360"/>
            <a:ext cx="37699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Wiki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13" name=""/>
          <p:cNvSpPr/>
          <p:nvPr/>
        </p:nvSpPr>
        <p:spPr>
          <a:xfrm>
            <a:off x="4542480" y="279360"/>
            <a:ext cx="462024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 Informatics Entry in Wikipedia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15" name=""/>
          <p:cNvSpPr/>
          <p:nvPr/>
        </p:nvSpPr>
        <p:spPr>
          <a:xfrm>
            <a:off x="6660360" y="366840"/>
            <a:ext cx="23767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Wikis: Easy Editing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826920" y="5048280"/>
            <a:ext cx="287640" cy="216000"/>
          </a:xfrm>
          <a:prstGeom prst="leftArrow">
            <a:avLst>
              <a:gd name="adj1" fmla="val 50000"/>
              <a:gd name="adj2" fmla="val 33292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18" name=""/>
          <p:cNvSpPr/>
          <p:nvPr/>
        </p:nvSpPr>
        <p:spPr>
          <a:xfrm>
            <a:off x="5508720" y="366840"/>
            <a:ext cx="349560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Wikis: Versioning Capability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20" name=""/>
          <p:cNvSpPr/>
          <p:nvPr/>
        </p:nvSpPr>
        <p:spPr>
          <a:xfrm>
            <a:off x="5508720" y="366840"/>
            <a:ext cx="349560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Wikis: Versioning Capability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309840" y="3922560"/>
            <a:ext cx="5543640" cy="1372680"/>
          </a:xfrm>
          <a:prstGeom prst="rect">
            <a:avLst/>
          </a:prstGeom>
          <a:solidFill>
            <a:srgbClr val="ffff99">
              <a:alpha val="60000"/>
            </a:srgbClr>
          </a:solidFill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111111"/>
                </a:solidFill>
                <a:latin typeface="Tahoma"/>
              </a:rPr>
              <a:t>Tip: Citing a wiki page in your work can be very tricky (unless one uses the new ‘</a:t>
            </a:r>
            <a:r>
              <a:rPr b="1" lang="en-GB" sz="1400" spc="-1" strike="noStrike">
                <a:solidFill>
                  <a:srgbClr val="111111"/>
                </a:solidFill>
                <a:latin typeface="Tahoma"/>
              </a:rPr>
              <a:t>permanent link</a:t>
            </a:r>
            <a:r>
              <a:rPr b="0" lang="en-GB" sz="1400" spc="-1" strike="noStrike">
                <a:solidFill>
                  <a:srgbClr val="111111"/>
                </a:solidFill>
                <a:latin typeface="Tahoma"/>
              </a:rPr>
              <a:t>’ feature in MediaWiki to point to a </a:t>
            </a:r>
            <a:r>
              <a:rPr b="0" i="1" lang="en-GB" sz="1400" spc="-1" strike="noStrike" u="sng">
                <a:solidFill>
                  <a:srgbClr val="111111"/>
                </a:solidFill>
                <a:uFillTx/>
                <a:latin typeface="Tahoma"/>
              </a:rPr>
              <a:t>specific revision</a:t>
            </a:r>
            <a:r>
              <a:rPr b="0" lang="en-GB" sz="1400" spc="-1" strike="noStrike">
                <a:solidFill>
                  <a:srgbClr val="111111"/>
                </a:solidFill>
                <a:latin typeface="Tahoma"/>
              </a:rPr>
              <a:t> of that page). Because of the dynamic editable nature of wikis, a page might significantly change and become a totally different article than the one you were originally referring to (while still maintaining the same URL).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H="1">
            <a:off x="1042560" y="5300640"/>
            <a:ext cx="2305080" cy="289080"/>
          </a:xfrm>
          <a:prstGeom prst="line">
            <a:avLst/>
          </a:prstGeom>
          <a:ln w="19080">
            <a:solidFill>
              <a:srgbClr val="ff0000"/>
            </a:solidFill>
            <a:miter/>
            <a:tailEnd len="med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24" name=""/>
          <p:cNvSpPr/>
          <p:nvPr/>
        </p:nvSpPr>
        <p:spPr>
          <a:xfrm>
            <a:off x="5724360" y="366840"/>
            <a:ext cx="327996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Wikis: Comparing Version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26" name=""/>
          <p:cNvSpPr/>
          <p:nvPr/>
        </p:nvSpPr>
        <p:spPr>
          <a:xfrm>
            <a:off x="5724360" y="366840"/>
            <a:ext cx="327996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Wikis: Article Discussion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380520"/>
            <a:ext cx="8229600" cy="1319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More Info</a:t>
            </a: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…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468360" y="1844640"/>
            <a:ext cx="8229600" cy="440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-3290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http://www.educause.edu/ir/library/pdf/ELI7004.pdf</a:t>
            </a:r>
            <a:br>
              <a:rPr sz="2400"/>
            </a:br>
            <a:br>
              <a:rPr sz="2400"/>
            </a:br>
            <a:br>
              <a:rPr sz="2400"/>
            </a:br>
            <a:br>
              <a:rPr sz="2400"/>
            </a:br>
            <a:r>
              <a:rPr b="0" lang="en-GB" sz="2400" spc="-1" strike="noStrike" u="sng">
                <a:solidFill>
                  <a:srgbClr val="00ccff"/>
                </a:solidFill>
                <a:uFillTx/>
                <a:latin typeface="Tahoma"/>
              </a:rPr>
              <a:t> 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29040" indent="-329040">
              <a:lnSpc>
                <a:spcPct val="90000"/>
              </a:lnSpc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Applying the Open Source Development Model to Knowledge Work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GB" sz="20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://siepr.stanford.edu/programs/OpenSoftware_David/oswp2.pdf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marL="329040" indent="-3290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Wiki Research Bibliography http://tools.wikimedia.de/~voj/bibliography/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29040" indent="-3290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Geowikis 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(The wikification of GIS, maps and satellite imagery/aerial photography: imaging and geospatial information for the wide masses)</a:t>
            </a:r>
            <a:br>
              <a:rPr sz="2400"/>
            </a:b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http://www.ij-healthgeographics.com/content/4/1/22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129" name="" descr=""/>
          <p:cNvPicPr/>
          <p:nvPr/>
        </p:nvPicPr>
        <p:blipFill>
          <a:blip r:embed="rId4"/>
          <a:stretch/>
        </p:blipFill>
        <p:spPr>
          <a:xfrm>
            <a:off x="3784680" y="2428920"/>
            <a:ext cx="3390840" cy="880920"/>
          </a:xfrm>
          <a:prstGeom prst="rect">
            <a:avLst/>
          </a:prstGeom>
          <a:ln w="0">
            <a:noFill/>
          </a:ln>
        </p:spPr>
      </p:pic>
      <p:pic>
        <p:nvPicPr>
          <p:cNvPr id="130" name="" descr=""/>
          <p:cNvPicPr/>
          <p:nvPr/>
        </p:nvPicPr>
        <p:blipFill>
          <a:blip r:embed="rId5"/>
          <a:srcRect l="49799" t="71017" r="7383" b="9272"/>
          <a:stretch/>
        </p:blipFill>
        <p:spPr>
          <a:xfrm>
            <a:off x="911160" y="2440080"/>
            <a:ext cx="2871720" cy="863640"/>
          </a:xfrm>
          <a:prstGeom prst="rect">
            <a:avLst/>
          </a:prstGeom>
          <a:ln w="9360">
            <a:solidFill>
              <a:srgbClr val="2b5481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Blogs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/>
          </p:nvPr>
        </p:nvSpPr>
        <p:spPr>
          <a:xfrm>
            <a:off x="457200" y="1844640"/>
            <a:ext cx="8229600" cy="4608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A related Web information sharing technology is the ‘blog’. A blog (WeBLOG) is a Web site that contains dated entries in reverse chronological order (most recent first) about a particular topic.*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Functioning as an online journal, blogs can be written by one person or a group of contributors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45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Entries contain commentary and links to other Web sites, and images as well as a search facility may also be included.</a:t>
            </a:r>
            <a:br>
              <a:rPr sz="2400"/>
            </a:br>
            <a:br>
              <a:rPr sz="1800"/>
            </a:br>
            <a:br>
              <a:rPr sz="1800"/>
            </a:b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* 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http://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www.answers.com/topic/blog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189000"/>
            <a:ext cx="8229600" cy="107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Agenda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457200" y="1483920"/>
            <a:ext cx="8229600" cy="504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Introduction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Wikis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Blogs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Podcasts and m-Learning 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(Mobile Learning)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General Advantages 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(Ease of Use, Free/Open Source Software/Hosting Options)</a:t>
            </a: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, Disadvantages 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(Vandalism and Quality Issues, Content Copyrights)</a:t>
            </a: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and Remedies</a:t>
            </a: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(Monitoring and Moderation, ‘Closed Environment’ Scenario)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200" spc="-1" strike="noStrike">
                <a:solidFill>
                  <a:srgbClr val="ffffff"/>
                </a:solidFill>
                <a:latin typeface="Tahoma"/>
              </a:rPr>
              <a:t>What’s Next?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1908000" y="1125360"/>
            <a:ext cx="7025040" cy="71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://casesblog.blogspot.com</a:t>
            </a:r>
            <a:r>
              <a:rPr b="0" lang="en-US" sz="1800" spc="-1" strike="noStrike">
                <a:solidFill>
                  <a:srgbClr val="111111"/>
                </a:solidFill>
                <a:latin typeface="Tahoma"/>
              </a:rPr>
              <a:t>    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http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://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6"/>
              </a:rPr>
              <a:t>clinicalcases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7"/>
              </a:rPr>
              <a:t>.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8"/>
              </a:rPr>
              <a:t>blogspot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9"/>
              </a:rPr>
              <a:t>.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10"/>
              </a:rPr>
              <a:t>com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11"/>
              </a:rPr>
              <a:t>/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398560" y="279360"/>
            <a:ext cx="3809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Blog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37" name=""/>
          <p:cNvSpPr/>
          <p:nvPr/>
        </p:nvSpPr>
        <p:spPr>
          <a:xfrm>
            <a:off x="5398560" y="279360"/>
            <a:ext cx="3809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Blog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39" name=""/>
          <p:cNvSpPr/>
          <p:nvPr/>
        </p:nvSpPr>
        <p:spPr>
          <a:xfrm>
            <a:off x="5398560" y="279360"/>
            <a:ext cx="3809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Blog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41" name=""/>
          <p:cNvSpPr/>
          <p:nvPr/>
        </p:nvSpPr>
        <p:spPr>
          <a:xfrm>
            <a:off x="5398560" y="136440"/>
            <a:ext cx="3809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Blog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7020000" y="981000"/>
            <a:ext cx="1873080" cy="1440000"/>
          </a:xfrm>
          <a:prstGeom prst="wedgeRoundRectCallout">
            <a:avLst>
              <a:gd name="adj1" fmla="val -66356"/>
              <a:gd name="adj2" fmla="val -53638"/>
              <a:gd name="adj3" fmla="val 16667"/>
            </a:avLst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Automatic Feed Detection in Internet Explorer 7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43" name="" descr=""/>
          <p:cNvPicPr/>
          <p:nvPr/>
        </p:nvPicPr>
        <p:blipFill>
          <a:blip r:embed="rId3"/>
          <a:stretch/>
        </p:blipFill>
        <p:spPr>
          <a:xfrm>
            <a:off x="7956720" y="2529000"/>
            <a:ext cx="930240" cy="93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" name="" descr=""/>
          <p:cNvPicPr/>
          <p:nvPr/>
        </p:nvPicPr>
        <p:blipFill>
          <a:blip r:embed="rId2"/>
          <a:stretch/>
        </p:blipFill>
        <p:spPr>
          <a:xfrm>
            <a:off x="1042920" y="0"/>
            <a:ext cx="7093080" cy="6831000"/>
          </a:xfrm>
          <a:prstGeom prst="rect">
            <a:avLst/>
          </a:prstGeom>
          <a:ln w="0">
            <a:noFill/>
          </a:ln>
        </p:spPr>
      </p:pic>
      <p:sp>
        <p:nvSpPr>
          <p:cNvPr id="145" name=""/>
          <p:cNvSpPr/>
          <p:nvPr/>
        </p:nvSpPr>
        <p:spPr>
          <a:xfrm>
            <a:off x="5398560" y="279360"/>
            <a:ext cx="3809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Blog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979280" y="3789360"/>
            <a:ext cx="3394800" cy="4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://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digutmb.blogspot.com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/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" descr=""/>
          <p:cNvPicPr/>
          <p:nvPr/>
        </p:nvPicPr>
        <p:blipFill>
          <a:blip r:embed="rId2"/>
          <a:stretch/>
        </p:blipFill>
        <p:spPr>
          <a:xfrm>
            <a:off x="0" y="0"/>
            <a:ext cx="7362720" cy="6810480"/>
          </a:xfrm>
          <a:prstGeom prst="rect">
            <a:avLst/>
          </a:prstGeom>
          <a:ln w="0">
            <a:noFill/>
          </a:ln>
        </p:spPr>
      </p:pic>
      <p:pic>
        <p:nvPicPr>
          <p:cNvPr id="148" name="" descr=""/>
          <p:cNvPicPr/>
          <p:nvPr/>
        </p:nvPicPr>
        <p:blipFill>
          <a:blip r:embed="rId3"/>
          <a:stretch/>
        </p:blipFill>
        <p:spPr>
          <a:xfrm>
            <a:off x="7453440" y="2381400"/>
            <a:ext cx="1400040" cy="4406760"/>
          </a:xfrm>
          <a:prstGeom prst="rect">
            <a:avLst/>
          </a:prstGeom>
          <a:ln w="0">
            <a:noFill/>
          </a:ln>
        </p:spPr>
      </p:pic>
      <p:sp>
        <p:nvSpPr>
          <p:cNvPr id="149" name=""/>
          <p:cNvSpPr/>
          <p:nvPr/>
        </p:nvSpPr>
        <p:spPr>
          <a:xfrm>
            <a:off x="4500720" y="1197000"/>
            <a:ext cx="4321080" cy="1310760"/>
          </a:xfrm>
          <a:prstGeom prst="rect">
            <a:avLst/>
          </a:prstGeom>
          <a:solidFill>
            <a:srgbClr val="ffff99">
              <a:alpha val="60000"/>
            </a:srgbClr>
          </a:solidFill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111111"/>
                </a:solidFill>
                <a:latin typeface="Tahoma"/>
              </a:rPr>
              <a:t>Each post to the blog is also a standalone Web page with a unique URL. This facilitates linking to and organising content within the same blog and from external sites.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H="1" flipV="1">
            <a:off x="4642920" y="476280"/>
            <a:ext cx="360360" cy="720720"/>
          </a:xfrm>
          <a:prstGeom prst="line">
            <a:avLst/>
          </a:prstGeom>
          <a:ln w="19080">
            <a:solidFill>
              <a:srgbClr val="ff0000"/>
            </a:solidFill>
            <a:miter/>
            <a:tailEnd len="med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7451640" y="2349360"/>
            <a:ext cx="1008000" cy="28764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7021800" y="260280"/>
            <a:ext cx="182664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Blog Featur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54" name=""/>
          <p:cNvSpPr/>
          <p:nvPr/>
        </p:nvSpPr>
        <p:spPr>
          <a:xfrm>
            <a:off x="5292720" y="836640"/>
            <a:ext cx="3503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Blog Features: Easy Posting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067280" y="2708280"/>
            <a:ext cx="4752720" cy="146556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Posting a clinical photo from your digital camera directly to your blog after optimisation and adding your comments can also be made at the touch of a button using a free Google product called Picasa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157" name=""/>
          <p:cNvSpPr/>
          <p:nvPr/>
        </p:nvSpPr>
        <p:spPr>
          <a:xfrm>
            <a:off x="6116040" y="1165320"/>
            <a:ext cx="2949120" cy="4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://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picasa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6"/>
              </a:rPr>
              <a:t>.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7"/>
              </a:rPr>
              <a:t>google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8"/>
              </a:rPr>
              <a:t>.</a:t>
            </a:r>
            <a:r>
              <a:rPr b="0" lang="en-US" sz="1800" spc="-1" strike="noStrike" u="sng">
                <a:solidFill>
                  <a:srgbClr val="00ccff"/>
                </a:solidFill>
                <a:uFillTx/>
                <a:latin typeface="Tahoma"/>
                <a:hlinkClick r:id="rId9"/>
              </a:rPr>
              <a:t>com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10"/>
              </a:rPr>
              <a:t>/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58" name="" descr=""/>
          <p:cNvPicPr/>
          <p:nvPr/>
        </p:nvPicPr>
        <p:blipFill>
          <a:blip r:embed="rId11"/>
          <a:stretch/>
        </p:blipFill>
        <p:spPr>
          <a:xfrm>
            <a:off x="4716360" y="4243320"/>
            <a:ext cx="4170600" cy="1306440"/>
          </a:xfrm>
          <a:prstGeom prst="rect">
            <a:avLst/>
          </a:prstGeom>
          <a:ln w="9360">
            <a:solidFill>
              <a:srgbClr val="333333"/>
            </a:solidFill>
            <a:miter/>
          </a:ln>
        </p:spPr>
      </p:pic>
      <p:sp>
        <p:nvSpPr>
          <p:cNvPr id="159" name=""/>
          <p:cNvSpPr/>
          <p:nvPr/>
        </p:nvSpPr>
        <p:spPr>
          <a:xfrm flipV="1">
            <a:off x="6443640" y="5551560"/>
            <a:ext cx="0" cy="627120"/>
          </a:xfrm>
          <a:prstGeom prst="line">
            <a:avLst/>
          </a:prstGeom>
          <a:ln w="1584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5219640" y="404640"/>
            <a:ext cx="371952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Blog Features: Posting Photo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71280" y="2457360"/>
            <a:ext cx="1800360" cy="338580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Also these days mobile phones with 2+ megapixel cameras can instantly post high resolution clinical photos to photoblogs/ moblogs on the Web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" descr=""/>
          <p:cNvPicPr/>
          <p:nvPr/>
        </p:nvPicPr>
        <p:blipFill>
          <a:blip r:embed="rId2"/>
          <a:stretch/>
        </p:blipFill>
        <p:spPr>
          <a:xfrm>
            <a:off x="1332000" y="0"/>
            <a:ext cx="6511680" cy="6858000"/>
          </a:xfrm>
          <a:prstGeom prst="rect">
            <a:avLst/>
          </a:prstGeom>
          <a:ln w="0">
            <a:noFill/>
          </a:ln>
        </p:spPr>
      </p:pic>
      <p:sp>
        <p:nvSpPr>
          <p:cNvPr id="163" name=""/>
          <p:cNvSpPr/>
          <p:nvPr/>
        </p:nvSpPr>
        <p:spPr>
          <a:xfrm>
            <a:off x="5435640" y="189000"/>
            <a:ext cx="35035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Blog Features: Easy Posting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4" name="" descr=""/>
          <p:cNvPicPr/>
          <p:nvPr/>
        </p:nvPicPr>
        <p:blipFill>
          <a:blip r:embed="rId2"/>
          <a:stretch/>
        </p:blipFill>
        <p:spPr>
          <a:xfrm>
            <a:off x="179280" y="0"/>
            <a:ext cx="7058160" cy="6810480"/>
          </a:xfrm>
          <a:prstGeom prst="rect">
            <a:avLst/>
          </a:prstGeom>
          <a:ln w="0">
            <a:noFill/>
          </a:ln>
        </p:spPr>
      </p:pic>
      <p:sp>
        <p:nvSpPr>
          <p:cNvPr id="165" name=""/>
          <p:cNvSpPr/>
          <p:nvPr/>
        </p:nvSpPr>
        <p:spPr>
          <a:xfrm>
            <a:off x="4716360" y="298440"/>
            <a:ext cx="422460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Blog Features: Readers’ Comment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188640"/>
            <a:ext cx="8229600" cy="93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Introduction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457200" y="1267920"/>
            <a:ext cx="8229600" cy="518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The latest generation of collaborative Web-based tools, namely wikis, blogs/photoblogs and podcasts/vodcasts, offer many unique and powerful information sharing and collaboration features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They also have the added advantage of taking the technical skill out of these features; allowing users to focus on the information and collaborative tasks themselves—minus delivery obstacles 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Wikis, blogs/photoblogs and podcasts/vodcasts carry the potential of complementing, improving and adding new collaborative dimensions to the many Web-based medical/health education, CPD*, and research services we have today.</a:t>
            </a:r>
            <a:br>
              <a:rPr sz="2400"/>
            </a:br>
            <a:br>
              <a:rPr sz="1600"/>
            </a:b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* CPD = Continuing Professional Development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More Info</a:t>
            </a: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…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67" name="PlaceHolder 2"/>
          <p:cNvSpPr>
            <a:spLocks noGrp="1"/>
          </p:cNvSpPr>
          <p:nvPr>
            <p:ph/>
          </p:nvPr>
        </p:nvSpPr>
        <p:spPr>
          <a:xfrm>
            <a:off x="456840" y="1980720"/>
            <a:ext cx="7931160" cy="5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http://www.educause.edu/ir/library/pdf/ELI7006.pdf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168" name="" descr=""/>
          <p:cNvPicPr/>
          <p:nvPr/>
        </p:nvPicPr>
        <p:blipFill>
          <a:blip r:embed="rId3"/>
          <a:srcRect l="49799" t="71017" r="7383" b="9272"/>
          <a:stretch/>
        </p:blipFill>
        <p:spPr>
          <a:xfrm>
            <a:off x="900000" y="2576520"/>
            <a:ext cx="2872080" cy="863640"/>
          </a:xfrm>
          <a:prstGeom prst="rect">
            <a:avLst/>
          </a:prstGeom>
          <a:ln w="9360">
            <a:solidFill>
              <a:srgbClr val="2b5481"/>
            </a:solidFill>
            <a:miter/>
          </a:ln>
        </p:spPr>
      </p:pic>
      <p:sp>
        <p:nvSpPr>
          <p:cNvPr id="169" name=""/>
          <p:cNvSpPr/>
          <p:nvPr/>
        </p:nvSpPr>
        <p:spPr>
          <a:xfrm>
            <a:off x="773280" y="3789360"/>
            <a:ext cx="77594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“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Because blogs engage people in knowledgge sharing, reflection, and debate, they often attract a large and dedicated readership.”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70" name="" descr=""/>
          <p:cNvPicPr/>
          <p:nvPr/>
        </p:nvPicPr>
        <p:blipFill>
          <a:blip r:embed="rId4"/>
          <a:stretch/>
        </p:blipFill>
        <p:spPr>
          <a:xfrm>
            <a:off x="3778200" y="2583000"/>
            <a:ext cx="3457800" cy="861840"/>
          </a:xfrm>
          <a:prstGeom prst="rect">
            <a:avLst/>
          </a:prstGeom>
          <a:ln w="9360">
            <a:solidFill>
              <a:srgbClr val="2b5481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Podcasts and m-Learning (Mobile Learning)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980720"/>
            <a:ext cx="8075520" cy="432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-3290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“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Podcasting’s essence is about creating content (audio or video—</a:t>
            </a:r>
            <a:r>
              <a:rPr b="0" i="1" lang="en-GB" sz="2400" spc="-1" strike="noStrike">
                <a:solidFill>
                  <a:srgbClr val="ffffff"/>
                </a:solidFill>
                <a:latin typeface="Tahoma"/>
              </a:rPr>
              <a:t>vodcasts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) for an audience that wants to listen when they want, where they want, and how they want.”*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29040" indent="-3290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Advantages: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lvl="1" marL="713160" indent="-274320">
              <a:lnSpc>
                <a:spcPct val="90000"/>
              </a:lnSpc>
              <a:spcBef>
                <a:spcPts val="4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Listen on your computer or download to portable MP3 players and listen on the move/anywhere (perfect for the busy health professional). But audio and video files can be large in size; users must have sufficient bandwidth to download them.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1" marL="713160" indent="-274320">
              <a:lnSpc>
                <a:spcPct val="90000"/>
              </a:lnSpc>
              <a:spcBef>
                <a:spcPts val="400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Support for auditory learners (it is claimed that the primary learning style in at least 30% of learners is auditory).</a:t>
            </a:r>
            <a:br>
              <a:rPr sz="2000"/>
            </a:br>
            <a:br>
              <a:rPr sz="1600"/>
            </a:b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  <a:p>
            <a:pPr lvl="1" marL="713160"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* 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http://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en.wikipedia.org/wiki/Podcast</a:t>
            </a:r>
            <a:endParaRPr b="0" lang="en-US" sz="18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173" name="" descr=""/>
          <p:cNvPicPr/>
          <p:nvPr/>
        </p:nvPicPr>
        <p:blipFill>
          <a:blip r:embed="rId4"/>
          <a:stretch/>
        </p:blipFill>
        <p:spPr>
          <a:xfrm>
            <a:off x="7667640" y="5381640"/>
            <a:ext cx="1476360" cy="147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4392720"/>
          </a:xfrm>
          <a:prstGeom prst="rect">
            <a:avLst/>
          </a:prstGeom>
          <a:ln w="0">
            <a:noFill/>
          </a:ln>
        </p:spPr>
      </p:pic>
      <p:sp>
        <p:nvSpPr>
          <p:cNvPr id="175" name=""/>
          <p:cNvSpPr/>
          <p:nvPr/>
        </p:nvSpPr>
        <p:spPr>
          <a:xfrm>
            <a:off x="17640" y="4365720"/>
            <a:ext cx="8964360" cy="26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Tahoma"/>
              </a:rPr>
              <a:t>Source: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Meng P. </a:t>
            </a:r>
            <a:r>
              <a:rPr b="1" i="1" lang="en-GB" sz="1600" spc="-1" strike="noStrike">
                <a:solidFill>
                  <a:srgbClr val="ffffff"/>
                </a:solidFill>
                <a:latin typeface="Tahoma"/>
              </a:rPr>
              <a:t>Podcasting and Vodcasting: A White Paper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. University of Missouri, 2005</a:t>
            </a:r>
            <a:br>
              <a:rPr sz="1600"/>
            </a:br>
            <a:r>
              <a:rPr b="0" lang="en-GB" sz="16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://edmarketing.apple.com/adcinstitute/wp-content/Missouri_Podcasting_White_Paper.pdf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The above ‘white paper’ by Peter Meng of the University of Missouri contains excellent </a:t>
            </a:r>
            <a:r>
              <a:rPr b="0" i="1" lang="en-GB" sz="1800" spc="-1" strike="noStrike" u="sng">
                <a:solidFill>
                  <a:srgbClr val="ffffff"/>
                </a:solidFill>
                <a:uFillTx/>
                <a:latin typeface="Tahoma"/>
              </a:rPr>
              <a:t>How to Podcast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 and </a:t>
            </a:r>
            <a:r>
              <a:rPr b="0" i="1" lang="en-GB" sz="1800" spc="-1" strike="noStrike" u="sng">
                <a:solidFill>
                  <a:srgbClr val="ffffff"/>
                </a:solidFill>
                <a:uFillTx/>
                <a:latin typeface="Tahoma"/>
              </a:rPr>
              <a:t>How to VODcast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 sections. Meng also describes many educational applications of podcasting and videocasting, including: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ffff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500" spc="-1" strike="noStrike">
                <a:solidFill>
                  <a:srgbClr val="ffffff"/>
                </a:solidFill>
                <a:latin typeface="Tahoma"/>
              </a:rPr>
              <a:t>Recordings of lectures for those students unable to attend the lecture in person;</a:t>
            </a:r>
            <a:endParaRPr b="0" lang="en-US" sz="15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ffff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500" spc="-1" strike="noStrike">
                <a:solidFill>
                  <a:srgbClr val="ffffff"/>
                </a:solidFill>
                <a:latin typeface="Tahoma"/>
              </a:rPr>
              <a:t>Audio recordings of textbook text by chapter, would allow students to “read” or review texts while walking or driving to class (significant aid to auditory learners); and</a:t>
            </a:r>
            <a:endParaRPr b="0" lang="en-US" sz="15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ffffff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500" spc="-1" strike="noStrike">
                <a:solidFill>
                  <a:srgbClr val="ffffff"/>
                </a:solidFill>
                <a:latin typeface="Tahoma"/>
              </a:rPr>
              <a:t>Downloadable libraries of high resolution heart and respiratory sounds for medical students.</a:t>
            </a:r>
            <a:endParaRPr b="0" lang="en-US" sz="15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76" name="" descr=""/>
          <p:cNvPicPr/>
          <p:nvPr/>
        </p:nvPicPr>
        <p:blipFill>
          <a:blip r:embed="rId4"/>
          <a:stretch/>
        </p:blipFill>
        <p:spPr>
          <a:xfrm>
            <a:off x="8318520" y="0"/>
            <a:ext cx="825480" cy="81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" descr=""/>
          <p:cNvPicPr/>
          <p:nvPr/>
        </p:nvPicPr>
        <p:blipFill>
          <a:blip r:embed="rId2"/>
          <a:stretch/>
        </p:blipFill>
        <p:spPr>
          <a:xfrm>
            <a:off x="0" y="1440"/>
            <a:ext cx="9144000" cy="6853320"/>
          </a:xfrm>
          <a:prstGeom prst="rect">
            <a:avLst/>
          </a:prstGeom>
          <a:ln w="0">
            <a:noFill/>
          </a:ln>
        </p:spPr>
      </p:pic>
      <p:sp>
        <p:nvSpPr>
          <p:cNvPr id="178" name=""/>
          <p:cNvSpPr/>
          <p:nvPr/>
        </p:nvSpPr>
        <p:spPr>
          <a:xfrm>
            <a:off x="5003640" y="279360"/>
            <a:ext cx="407700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Podcast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948200" y="3573360"/>
            <a:ext cx="4016520" cy="256284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buClr>
                <a:srgbClr val="111111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New York University ophthalmology CME programs via podcast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111111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Displayed here as an RSS feed in Windows Internet Explorer 7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111111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Users can subscribe to the feed to automatically receive updates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111111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They can use Windows Media Player to listen to the MP3 files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81" name=""/>
          <p:cNvSpPr/>
          <p:nvPr/>
        </p:nvSpPr>
        <p:spPr>
          <a:xfrm>
            <a:off x="5003640" y="279360"/>
            <a:ext cx="407700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Podcast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2" name="" descr=""/>
          <p:cNvPicPr/>
          <p:nvPr/>
        </p:nvPicPr>
        <p:blipFill>
          <a:blip r:embed="rId2"/>
          <a:stretch/>
        </p:blipFill>
        <p:spPr>
          <a:xfrm>
            <a:off x="0" y="189000"/>
            <a:ext cx="9144000" cy="6465960"/>
          </a:xfrm>
          <a:prstGeom prst="rect">
            <a:avLst/>
          </a:prstGeom>
          <a:ln w="0">
            <a:noFill/>
          </a:ln>
        </p:spPr>
      </p:pic>
      <p:sp>
        <p:nvSpPr>
          <p:cNvPr id="183" name=""/>
          <p:cNvSpPr/>
          <p:nvPr/>
        </p:nvSpPr>
        <p:spPr>
          <a:xfrm>
            <a:off x="3564000" y="5589720"/>
            <a:ext cx="360360" cy="144360"/>
          </a:xfrm>
          <a:prstGeom prst="line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003640" y="279360"/>
            <a:ext cx="407700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Podcast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85" name="" descr=""/>
          <p:cNvPicPr/>
          <p:nvPr/>
        </p:nvPicPr>
        <p:blipFill>
          <a:blip r:embed="rId3"/>
          <a:stretch/>
        </p:blipFill>
        <p:spPr>
          <a:xfrm>
            <a:off x="8839080" y="6308640"/>
            <a:ext cx="304920" cy="30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996" fill="hold"/>
                                        <p:tgtEl>
                                          <p:spTgt spid="18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591240"/>
          </a:xfrm>
          <a:prstGeom prst="rect">
            <a:avLst/>
          </a:prstGeom>
          <a:ln w="0">
            <a:noFill/>
          </a:ln>
        </p:spPr>
      </p:pic>
      <p:sp>
        <p:nvSpPr>
          <p:cNvPr id="187" name=""/>
          <p:cNvSpPr/>
          <p:nvPr/>
        </p:nvSpPr>
        <p:spPr>
          <a:xfrm>
            <a:off x="5545080" y="3897360"/>
            <a:ext cx="649440" cy="360360"/>
          </a:xfrm>
          <a:prstGeom prst="leftArrow">
            <a:avLst>
              <a:gd name="adj1" fmla="val 50000"/>
              <a:gd name="adj2" fmla="val 45055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589440"/>
          </a:xfrm>
          <a:prstGeom prst="rect">
            <a:avLst/>
          </a:prstGeom>
          <a:ln w="0">
            <a:noFill/>
          </a:ln>
        </p:spPr>
      </p:pic>
      <p:sp>
        <p:nvSpPr>
          <p:cNvPr id="189" name=""/>
          <p:cNvSpPr/>
          <p:nvPr/>
        </p:nvSpPr>
        <p:spPr>
          <a:xfrm>
            <a:off x="1476360" y="4724280"/>
            <a:ext cx="649440" cy="360360"/>
          </a:xfrm>
          <a:prstGeom prst="leftArrow">
            <a:avLst>
              <a:gd name="adj1" fmla="val 50000"/>
              <a:gd name="adj2" fmla="val 45055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476360" y="5589720"/>
            <a:ext cx="649440" cy="360360"/>
          </a:xfrm>
          <a:prstGeom prst="leftArrow">
            <a:avLst>
              <a:gd name="adj1" fmla="val 50000"/>
              <a:gd name="adj2" fmla="val 45055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6659640" y="3068640"/>
            <a:ext cx="2305080" cy="338580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You don’t need a dedicated ‘podcatcher program’ if you are running the latest Internet Explorer 7 (IE7)/Windows Vista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Podcasts use RSS, which is now natively supported by/built into IE7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" descr=""/>
          <p:cNvPicPr/>
          <p:nvPr/>
        </p:nvPicPr>
        <p:blipFill>
          <a:blip r:embed="rId2"/>
          <a:stretch/>
        </p:blipFill>
        <p:spPr>
          <a:xfrm>
            <a:off x="0" y="142920"/>
            <a:ext cx="9144000" cy="6591240"/>
          </a:xfrm>
          <a:prstGeom prst="rect">
            <a:avLst/>
          </a:prstGeom>
          <a:ln w="0">
            <a:noFill/>
          </a:ln>
        </p:spPr>
      </p:pic>
      <p:sp>
        <p:nvSpPr>
          <p:cNvPr id="193" name=""/>
          <p:cNvSpPr/>
          <p:nvPr/>
        </p:nvSpPr>
        <p:spPr>
          <a:xfrm>
            <a:off x="5003640" y="279360"/>
            <a:ext cx="407700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Podcast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338560" y="4508640"/>
            <a:ext cx="3385800" cy="232812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The </a:t>
            </a:r>
            <a:r>
              <a:rPr b="1" lang="en-GB" sz="1800" spc="-1" strike="noStrike">
                <a:solidFill>
                  <a:srgbClr val="111111"/>
                </a:solidFill>
                <a:latin typeface="Tahoma"/>
              </a:rPr>
              <a:t>Arizona Heart Institute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6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://www.cvmd.org/mission.php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and the </a:t>
            </a:r>
            <a:r>
              <a:rPr b="1" lang="en-GB" sz="1800" spc="-1" strike="noStrike">
                <a:solidFill>
                  <a:srgbClr val="111111"/>
                </a:solidFill>
                <a:latin typeface="Tahoma"/>
              </a:rPr>
              <a:t>Cleveland Clinic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http://www.clevelandclinic.org/</a:t>
            </a:r>
            <a:r>
              <a:rPr b="0" lang="en-GB" sz="16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healthedge/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offer video podcasts for </a:t>
            </a:r>
            <a:r>
              <a:rPr b="0" i="1" lang="en-GB" sz="1800" spc="-1" strike="noStrike" u="sng">
                <a:solidFill>
                  <a:srgbClr val="111111"/>
                </a:solidFill>
                <a:uFillTx/>
                <a:latin typeface="Tahoma"/>
              </a:rPr>
              <a:t>healthcare professionals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as well as for </a:t>
            </a:r>
            <a:r>
              <a:rPr b="0" i="1" lang="en-GB" sz="1800" spc="-1" strike="noStrike" u="sng">
                <a:solidFill>
                  <a:srgbClr val="111111"/>
                </a:solidFill>
                <a:uFillTx/>
                <a:latin typeface="Tahoma"/>
              </a:rPr>
              <a:t>patients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pic>
        <p:nvPicPr>
          <p:cNvPr id="196" name="" descr=""/>
          <p:cNvPicPr/>
          <p:nvPr/>
        </p:nvPicPr>
        <p:blipFill>
          <a:blip r:embed="rId3"/>
          <a:stretch/>
        </p:blipFill>
        <p:spPr>
          <a:xfrm>
            <a:off x="7380360" y="260280"/>
            <a:ext cx="1143000" cy="5916600"/>
          </a:xfrm>
          <a:prstGeom prst="rect">
            <a:avLst/>
          </a:prstGeom>
          <a:ln w="0">
            <a:noFill/>
          </a:ln>
        </p:spPr>
      </p:pic>
      <p:sp>
        <p:nvSpPr>
          <p:cNvPr id="197" name=""/>
          <p:cNvSpPr/>
          <p:nvPr/>
        </p:nvSpPr>
        <p:spPr>
          <a:xfrm>
            <a:off x="5867280" y="0"/>
            <a:ext cx="3276720" cy="5806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e5ffff"/>
                </a:solidFill>
                <a:latin typeface="Tahoma"/>
              </a:rPr>
              <a:t>Health/Medical Podcast Example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79280" y="2637000"/>
            <a:ext cx="1513080" cy="173988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Podcasts are already being used in medical school curricula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040" y="5516640"/>
            <a:ext cx="6439680" cy="33624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http://webweekly.hms.harvard.edu/archive/2006/0130/student_scene.html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2"/>
          <a:stretch/>
        </p:blipFill>
        <p:spPr>
          <a:xfrm>
            <a:off x="0" y="0"/>
            <a:ext cx="6410160" cy="685800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6516720" y="35280"/>
            <a:ext cx="2448000" cy="588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286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Kamel Boulos MN: 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Letter to Editor/Response by author (about: wikis, blogs and podcasts for virtual collaborative practice and learning/CPD in dermatology).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 </a:t>
            </a:r>
            <a:r>
              <a:rPr b="0" i="1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Indian J Dermatol Venereol Leprol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 </a:t>
            </a:r>
            <a:r>
              <a:rPr b="0" lang="en-GB" sz="2000" spc="-1" strike="noStrike" u="sng">
                <a:solidFill>
                  <a:srgbClr val="ffffff"/>
                </a:solidFill>
                <a:uFillTx/>
                <a:latin typeface="Tahoma"/>
                <a:ea typeface="SimSun"/>
              </a:rPr>
              <a:t>2006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, </a:t>
            </a:r>
            <a:r>
              <a:rPr b="1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72(3)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  <a:ea typeface="SimSun"/>
              </a:rPr>
              <a:t>:231-32 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  <a:ea typeface="SimSun"/>
              </a:rPr>
              <a:t>&lt;URL:</a:t>
            </a:r>
            <a:r>
              <a:rPr b="0" lang="en-GB" sz="1400" spc="-1" strike="noStrike">
                <a:solidFill>
                  <a:srgbClr val="ffffff"/>
                </a:solidFill>
                <a:latin typeface="Tahoma"/>
                <a:ea typeface="SimSun"/>
              </a:rPr>
              <a:t> 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  <a:ea typeface="SimSun"/>
              </a:rPr>
              <a:t>http://www.ijdvl.com/</a:t>
            </a:r>
            <a:r>
              <a:rPr b="0" lang="en-GB" sz="1400" spc="-1" strike="noStrike">
                <a:solidFill>
                  <a:srgbClr val="ffffff"/>
                </a:solidFill>
                <a:latin typeface="Tahoma"/>
                <a:ea typeface="SimSun"/>
              </a:rPr>
              <a:t>article.asp?issn=0378-6323;year=2006;volume=72;issue=3;spage=231;epage=232;aulast=Kamel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  <a:ea typeface="SimSun"/>
              </a:rPr>
              <a:t>&gt;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3"/>
          <a:stretch/>
        </p:blipFill>
        <p:spPr>
          <a:xfrm>
            <a:off x="3995640" y="6143760"/>
            <a:ext cx="5148360" cy="71424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2346480" y="2925720"/>
            <a:ext cx="4107960" cy="45972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e5ffff"/>
                </a:solidFill>
                <a:latin typeface="Tahoma"/>
              </a:rPr>
              <a:t>A Growing Interest: Articles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" descr=""/>
          <p:cNvPicPr/>
          <p:nvPr/>
        </p:nvPicPr>
        <p:blipFill>
          <a:blip r:embed="rId2"/>
          <a:stretch/>
        </p:blipFill>
        <p:spPr>
          <a:xfrm>
            <a:off x="1052640" y="4680"/>
            <a:ext cx="7038720" cy="6848640"/>
          </a:xfrm>
          <a:prstGeom prst="rect">
            <a:avLst/>
          </a:prstGeom>
          <a:ln w="0">
            <a:noFill/>
          </a:ln>
        </p:spPr>
      </p:pic>
      <p:sp>
        <p:nvSpPr>
          <p:cNvPr id="201" name=""/>
          <p:cNvSpPr/>
          <p:nvPr/>
        </p:nvSpPr>
        <p:spPr>
          <a:xfrm>
            <a:off x="5003640" y="279360"/>
            <a:ext cx="4077000" cy="70380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Podcast Directory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900000" y="5516640"/>
            <a:ext cx="3024360" cy="1081080"/>
          </a:xfrm>
          <a:prstGeom prst="ellipse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H="1">
            <a:off x="4356000" y="404640"/>
            <a:ext cx="503280" cy="0"/>
          </a:xfrm>
          <a:prstGeom prst="line">
            <a:avLst/>
          </a:prstGeom>
          <a:ln w="15840">
            <a:solidFill>
              <a:srgbClr val="ff0000"/>
            </a:solidFill>
            <a:miter/>
            <a:tailEnd len="med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More Info</a:t>
            </a: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…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0755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http://www.educause.edu/ir/library/pdf/ELI7003.pdf</a:t>
            </a:r>
            <a:br>
              <a:rPr sz="2400"/>
            </a:br>
            <a:br>
              <a:rPr sz="2000"/>
            </a:br>
            <a:br>
              <a:rPr sz="2000"/>
            </a:br>
            <a:br>
              <a:rPr sz="2000"/>
            </a:br>
            <a:r>
              <a:rPr b="0" lang="en-GB" sz="2000" spc="-1" strike="noStrike" u="sng">
                <a:solidFill>
                  <a:srgbClr val="ffffff"/>
                </a:solidFill>
                <a:uFillTx/>
                <a:latin typeface="Tahoma"/>
              </a:rPr>
              <a:t> 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Podcasting for health professionals </a:t>
            </a:r>
            <a:r>
              <a:rPr b="0" lang="en-GB" sz="20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http://denison.uchsc.edu/newsletter/issues/updateFEB06.html#3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Carleton University vodcast experiment </a:t>
            </a:r>
            <a:r>
              <a:rPr b="0" lang="en-GB" sz="24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http://</a:t>
            </a:r>
            <a:r>
              <a:rPr b="0" lang="en-GB" sz="24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www.carleton.ca/cutv/vod/vodcast.htm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206" name="" descr=""/>
          <p:cNvPicPr/>
          <p:nvPr/>
        </p:nvPicPr>
        <p:blipFill>
          <a:blip r:embed="rId6"/>
          <a:srcRect l="49799" t="71017" r="7383" b="9272"/>
          <a:stretch/>
        </p:blipFill>
        <p:spPr>
          <a:xfrm>
            <a:off x="900000" y="2576520"/>
            <a:ext cx="2872080" cy="863640"/>
          </a:xfrm>
          <a:prstGeom prst="rect">
            <a:avLst/>
          </a:prstGeom>
          <a:ln w="9360">
            <a:solidFill>
              <a:srgbClr val="2b5481"/>
            </a:solidFill>
            <a:miter/>
          </a:ln>
        </p:spPr>
      </p:pic>
      <p:pic>
        <p:nvPicPr>
          <p:cNvPr id="207" name="" descr=""/>
          <p:cNvPicPr/>
          <p:nvPr/>
        </p:nvPicPr>
        <p:blipFill>
          <a:blip r:embed="rId7"/>
          <a:stretch/>
        </p:blipFill>
        <p:spPr>
          <a:xfrm>
            <a:off x="3778200" y="2575080"/>
            <a:ext cx="3386160" cy="853920"/>
          </a:xfrm>
          <a:prstGeom prst="rect">
            <a:avLst/>
          </a:prstGeom>
          <a:ln w="9360">
            <a:solidFill>
              <a:srgbClr val="2b5481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457200" y="189000"/>
            <a:ext cx="8229600" cy="12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General Advantages, Disadvantages and Remedies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457200" y="1628640"/>
            <a:ext cx="8075520" cy="288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ffffff"/>
                </a:solidFill>
                <a:latin typeface="Tahoma"/>
              </a:rPr>
              <a:t>Two main big advantages: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i="1" lang="en-GB" sz="2400" spc="-1" strike="noStrike" u="sng">
                <a:solidFill>
                  <a:srgbClr val="ffffff"/>
                </a:solidFill>
                <a:uFillTx/>
                <a:latin typeface="Tahoma"/>
              </a:rPr>
              <a:t>Ease of use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and availability of many </a:t>
            </a:r>
            <a:r>
              <a:rPr b="0" i="1" lang="en-GB" sz="2400" spc="-1" strike="noStrike" u="sng">
                <a:solidFill>
                  <a:srgbClr val="ffffff"/>
                </a:solidFill>
                <a:uFillTx/>
                <a:latin typeface="Tahoma"/>
              </a:rPr>
              <a:t>Open Source/free/low-cost software and hosting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options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Examples of the latter include </a:t>
            </a:r>
            <a:r>
              <a:rPr b="1" lang="en-GB" sz="2400" spc="-1" strike="noStrike">
                <a:solidFill>
                  <a:srgbClr val="ffffff"/>
                </a:solidFill>
                <a:latin typeface="Tahoma"/>
              </a:rPr>
              <a:t>MediaWiki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http://www.mediawiki.org/wiki/MediaWiki 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(Open Source</a:t>
            </a:r>
            <a:r>
              <a:rPr b="0" lang="en-GB" sz="2000" spc="-1" strike="noStrike">
                <a:solidFill>
                  <a:srgbClr val="ffffff"/>
                </a:solidFill>
                <a:latin typeface="Symbol"/>
                <a:ea typeface="Symbol"/>
              </a:rPr>
              <a:t>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the same software package that runs Wikipedia)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and </a:t>
            </a:r>
            <a:r>
              <a:rPr b="1" lang="en-GB" sz="2400" spc="-1" strike="noStrike">
                <a:solidFill>
                  <a:srgbClr val="ffffff"/>
                </a:solidFill>
                <a:latin typeface="Tahoma"/>
              </a:rPr>
              <a:t>Google Blogger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(free) 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http://www.blogger.com/start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  <p:grpSp>
        <p:nvGrpSpPr>
          <p:cNvPr id="210" name=""/>
          <p:cNvGrpSpPr/>
          <p:nvPr/>
        </p:nvGrpSpPr>
        <p:grpSpPr>
          <a:xfrm>
            <a:off x="971640" y="4653000"/>
            <a:ext cx="7056360" cy="2205000"/>
            <a:chOff x="971640" y="4653000"/>
            <a:chExt cx="7056360" cy="2205000"/>
          </a:xfrm>
        </p:grpSpPr>
        <p:pic>
          <p:nvPicPr>
            <p:cNvPr id="211" name="" descr=""/>
            <p:cNvPicPr/>
            <p:nvPr/>
          </p:nvPicPr>
          <p:blipFill>
            <a:blip r:embed="rId2"/>
            <a:stretch/>
          </p:blipFill>
          <p:spPr>
            <a:xfrm>
              <a:off x="2930040" y="4653000"/>
              <a:ext cx="5097960" cy="2205000"/>
            </a:xfrm>
            <a:prstGeom prst="rect">
              <a:avLst/>
            </a:prstGeom>
            <a:ln w="9360">
              <a:solidFill>
                <a:srgbClr val="333333"/>
              </a:solidFill>
              <a:miter/>
            </a:ln>
          </p:spPr>
        </p:pic>
        <p:pic>
          <p:nvPicPr>
            <p:cNvPr id="212" name="" descr=""/>
            <p:cNvPicPr/>
            <p:nvPr/>
          </p:nvPicPr>
          <p:blipFill>
            <a:blip r:embed="rId3"/>
            <a:stretch/>
          </p:blipFill>
          <p:spPr>
            <a:xfrm>
              <a:off x="971640" y="4665240"/>
              <a:ext cx="2026080" cy="55404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213" name="" descr=""/>
          <p:cNvPicPr/>
          <p:nvPr/>
        </p:nvPicPr>
        <p:blipFill>
          <a:blip r:embed="rId4"/>
          <a:stretch/>
        </p:blipFill>
        <p:spPr>
          <a:xfrm>
            <a:off x="1006560" y="5322960"/>
            <a:ext cx="1836720" cy="1535040"/>
          </a:xfrm>
          <a:prstGeom prst="rect">
            <a:avLst/>
          </a:prstGeom>
          <a:ln w="9360">
            <a:solidFill>
              <a:srgbClr val="333333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380520"/>
            <a:ext cx="8229600" cy="110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Disadvantages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99920"/>
            <a:ext cx="822960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Wikis and blogs are sometimes prone to vandalism and, as a result, serious quality issues, because of their free form nature and the (relative/potential) lack of control over their content (though this can be the very strength of wikis and blogs—see http://meta.wikimedia.org/wiki/Darwikinism)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In an </a:t>
            </a:r>
            <a:r>
              <a:rPr b="0" i="1" lang="en-GB" sz="2400" spc="-1" strike="noStrike" u="sng">
                <a:solidFill>
                  <a:srgbClr val="ffffff"/>
                </a:solidFill>
                <a:uFillTx/>
                <a:latin typeface="Tahoma"/>
              </a:rPr>
              <a:t>open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 collaborative Web environment, anyone can very easily post copyrighted material without the permission of copyright holders, post otherwise unsuitable or misleading content, edit existing content in a way that reduces its quality/accuracy, or even delete/blank a good wiki entry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6" name="" descr=""/>
          <p:cNvPicPr/>
          <p:nvPr/>
        </p:nvPicPr>
        <p:blipFill>
          <a:blip r:embed="rId2"/>
          <a:srcRect l="16147" t="21662" r="24792" b="7713"/>
          <a:stretch/>
        </p:blipFill>
        <p:spPr>
          <a:xfrm>
            <a:off x="3743280" y="1341360"/>
            <a:ext cx="5400720" cy="4680000"/>
          </a:xfrm>
          <a:prstGeom prst="rect">
            <a:avLst/>
          </a:prstGeom>
          <a:ln w="0">
            <a:noFill/>
          </a:ln>
        </p:spPr>
      </p:pic>
      <p:sp>
        <p:nvSpPr>
          <p:cNvPr id="217" name=""/>
          <p:cNvSpPr/>
          <p:nvPr/>
        </p:nvSpPr>
        <p:spPr>
          <a:xfrm>
            <a:off x="250920" y="1341360"/>
            <a:ext cx="3384360" cy="545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2000" spc="-1" strike="noStrike" u="sng">
                <a:solidFill>
                  <a:srgbClr val="ffffff"/>
                </a:solidFill>
                <a:uFillTx/>
                <a:latin typeface="Tahoma"/>
              </a:rPr>
              <a:t>Lack of vital article meta-information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: All what one finds in wikis are IP addresses and nicknames. The lack of clear and complete authorship/ editorship information attached to each wiki entry, including authors’/editors’ affiliations and credentials, is a very serious quality issue encountered in most wiki-based encyclopaedias these days.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457200" y="189000"/>
            <a:ext cx="8229600" cy="93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Quality Issues – Cont’d</a:t>
            </a:r>
            <a:endParaRPr b="0" lang="en-US" sz="4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6084720" y="2708280"/>
            <a:ext cx="1008360" cy="331308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title"/>
          </p:nvPr>
        </p:nvSpPr>
        <p:spPr>
          <a:xfrm>
            <a:off x="457200" y="260280"/>
            <a:ext cx="82296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Remedies: Monitoring and Moderation of </a:t>
            </a:r>
            <a:r>
              <a:rPr b="0" lang="en-GB" sz="3600" spc="-1" strike="noStrike" u="sng">
                <a:solidFill>
                  <a:srgbClr val="e5ffff"/>
                </a:solidFill>
                <a:uFillTx/>
                <a:latin typeface="Tahoma"/>
              </a:rPr>
              <a:t>Open</a:t>
            </a: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 Wikis and Blogs 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23" name="PlaceHolder 2"/>
          <p:cNvSpPr>
            <a:spLocks noGrp="1"/>
          </p:cNvSpPr>
          <p:nvPr>
            <p:ph/>
          </p:nvPr>
        </p:nvSpPr>
        <p:spPr>
          <a:xfrm>
            <a:off x="457200" y="1844280"/>
            <a:ext cx="8229600" cy="4321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7000"/>
          </a:bodyPr>
          <a:p>
            <a:pPr marL="332640" indent="-3326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Monitoring and moderating posts, and deleting/ reverting (rollback) edits as necessary; protecting (rendering ‘read-only’) key/stable content; controlling who can post; blocking specific (problematic) users/IP addresses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32640" indent="-3326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Wiki and blog software packages have built-in Administrator’s functionalities to support these tasks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32640" indent="-332640">
              <a:lnSpc>
                <a:spcPct val="90000"/>
              </a:lnSpc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Can be very time-consuming/human resource intensive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32640" indent="-332640">
              <a:lnSpc>
                <a:spcPct val="90000"/>
              </a:lnSpc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Of interest:</a:t>
            </a:r>
            <a:br>
              <a:rPr sz="2400"/>
            </a:b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http://en.wikipedia.org/wiki/Wikipedia:Vandalism</a:t>
            </a:r>
            <a:br>
              <a:rPr sz="2000"/>
            </a:b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http://en.wikipedia.org/wiki/Wikipedia:Counter_Vandalism_Unit</a:t>
            </a:r>
            <a:br>
              <a:rPr sz="2000"/>
            </a:b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http://en.wikipedia.org/wiki/Wikipedia:Cleaning_up_vandalism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title"/>
          </p:nvPr>
        </p:nvSpPr>
        <p:spPr>
          <a:xfrm>
            <a:off x="457200" y="260280"/>
            <a:ext cx="8229600" cy="12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Remedies: ‘</a:t>
            </a:r>
            <a:r>
              <a:rPr b="0" lang="en-GB" sz="3600" spc="-1" strike="noStrike" u="sng">
                <a:solidFill>
                  <a:srgbClr val="e5ffff"/>
                </a:solidFill>
                <a:uFillTx/>
                <a:latin typeface="Tahoma"/>
              </a:rPr>
              <a:t>Closed</a:t>
            </a: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 Environment’ Scenario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25" name="PlaceHolder 2"/>
          <p:cNvSpPr>
            <a:spLocks noGrp="1"/>
          </p:cNvSpPr>
          <p:nvPr>
            <p:ph/>
          </p:nvPr>
        </p:nvSpPr>
        <p:spPr>
          <a:xfrm>
            <a:off x="457200" y="1700280"/>
            <a:ext cx="8229600" cy="446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4000"/>
          </a:bodyPr>
          <a:p>
            <a:pPr marL="322200" indent="-32220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Enforce, check, and limit wiki and blog registration and editing privileges to selected, well-defined, and verifiable special interest groups or communities of users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22200" indent="-32220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Posting/editing articles on these wikis and blogs will thus be </a:t>
            </a:r>
            <a:r>
              <a:rPr b="0" i="1" lang="en-GB" sz="2400" spc="-1" strike="noStrike" u="sng">
                <a:solidFill>
                  <a:srgbClr val="ffffff"/>
                </a:solidFill>
                <a:uFillTx/>
                <a:latin typeface="Tahoma"/>
              </a:rPr>
              <a:t>limited to select, well-known and trustworthy people</a:t>
            </a: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marL="322200" indent="-32220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Everyone else will still be able to access/read the wiki or blog and, if desirable/ required, also post limited (moderated) comments (to build a community).</a:t>
            </a:r>
            <a:br>
              <a:rPr sz="2400"/>
            </a:b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(Read-only access and posting limited moderated comments/discussion topics can also be blocked by the Administrator, if deemed necessary.)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Remedies: ‘</a:t>
            </a:r>
            <a:r>
              <a:rPr b="0" lang="en-GB" sz="3600" spc="-1" strike="noStrike" u="sng">
                <a:solidFill>
                  <a:srgbClr val="e5ffff"/>
                </a:solidFill>
                <a:uFillTx/>
                <a:latin typeface="Tahoma"/>
              </a:rPr>
              <a:t>Closed</a:t>
            </a:r>
            <a:r>
              <a:rPr b="0" lang="en-GB" sz="3600" spc="-1" strike="noStrike">
                <a:solidFill>
                  <a:srgbClr val="e5ffff"/>
                </a:solidFill>
                <a:latin typeface="Tahoma"/>
              </a:rPr>
              <a:t> Environment’ Scenario</a:t>
            </a:r>
            <a:endParaRPr b="0" lang="en-US" sz="36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075520" cy="245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ffffff"/>
                </a:solidFill>
                <a:latin typeface="Tahoma"/>
              </a:rPr>
              <a:t>Once a trustworthy expert is identified among external readers (based on the quality of his/her posted comments and further private communication with them), they can also be granted posting/editing privileges (and in this way the (closed) pool of editors will keep growing).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228" name="" descr=""/>
          <p:cNvPicPr/>
          <p:nvPr/>
        </p:nvPicPr>
        <p:blipFill>
          <a:blip r:embed="rId2"/>
          <a:stretch/>
        </p:blipFill>
        <p:spPr>
          <a:xfrm>
            <a:off x="900000" y="4508640"/>
            <a:ext cx="5040360" cy="1874520"/>
          </a:xfrm>
          <a:prstGeom prst="rect">
            <a:avLst/>
          </a:prstGeom>
          <a:ln w="9360">
            <a:solidFill>
              <a:srgbClr val="333333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" descr=""/>
          <p:cNvPicPr/>
          <p:nvPr/>
        </p:nvPicPr>
        <p:blipFill>
          <a:blip r:embed="rId2"/>
          <a:stretch/>
        </p:blipFill>
        <p:spPr>
          <a:xfrm>
            <a:off x="0" y="0"/>
            <a:ext cx="4800600" cy="685800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3"/>
          <a:stretch/>
        </p:blipFill>
        <p:spPr>
          <a:xfrm>
            <a:off x="4589640" y="0"/>
            <a:ext cx="4554360" cy="685800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1298160" y="5300640"/>
            <a:ext cx="4541040" cy="52056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e5ffff"/>
                </a:solidFill>
                <a:latin typeface="Tahoma"/>
              </a:rPr>
              <a:t>A Growing Interest: Books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9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230" name=""/>
          <p:cNvSpPr/>
          <p:nvPr/>
        </p:nvSpPr>
        <p:spPr>
          <a:xfrm>
            <a:off x="34920" y="2115720"/>
            <a:ext cx="1835280" cy="301428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111111"/>
                </a:solidFill>
                <a:latin typeface="Tahoma"/>
              </a:rPr>
              <a:t>“</a:t>
            </a:r>
            <a:r>
              <a:rPr b="0" lang="en-US" sz="1600" spc="-1" strike="noStrike">
                <a:solidFill>
                  <a:srgbClr val="111111"/>
                </a:solidFill>
                <a:latin typeface="Tahoma"/>
              </a:rPr>
              <a:t>A wiki on gene function, which utilizes the collective brain power of biologists around the world, would be an invaluable tool for biological sciences</a:t>
            </a:r>
            <a:r>
              <a:rPr b="0" lang="en-GB" sz="1600" spc="-1" strike="noStrike">
                <a:solidFill>
                  <a:srgbClr val="111111"/>
                </a:solidFill>
                <a:latin typeface="Tahoma"/>
              </a:rPr>
              <a:t>.”</a:t>
            </a:r>
            <a:r>
              <a:rPr b="0" lang="en-US" sz="1600" spc="-1" strike="noStrike">
                <a:solidFill>
                  <a:srgbClr val="111111"/>
                </a:solidFill>
                <a:latin typeface="Tahoma"/>
              </a:rPr>
              <a:t> 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400" spc="-1" strike="noStrike">
                <a:solidFill>
                  <a:srgbClr val="e5ffff"/>
                </a:solidFill>
                <a:latin typeface="Tahoma"/>
              </a:rPr>
              <a:t>What’s Next?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400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10000"/>
              </a:lnSpc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Careful thinking is needed in order to find the </a:t>
            </a:r>
            <a:r>
              <a:rPr b="0" i="1" lang="en-GB" sz="2800" spc="-1" strike="noStrike" u="sng">
                <a:solidFill>
                  <a:srgbClr val="ffffff"/>
                </a:solidFill>
                <a:uFillTx/>
                <a:latin typeface="Tahoma"/>
              </a:rPr>
              <a:t>best ways</a:t>
            </a: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 to use these emerging tools to boost our productivity, foster better ‘communities of practice’, and support our continuing professional development (CPD).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110000"/>
              </a:lnSpc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ffffff"/>
                </a:solidFill>
                <a:latin typeface="Tahoma"/>
              </a:rPr>
              <a:t>Stakeholders’/prospective users’ representatives (healthcare professionals and students) must be adequately involved in this process.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3" name="" descr=""/>
          <p:cNvPicPr/>
          <p:nvPr/>
        </p:nvPicPr>
        <p:blipFill>
          <a:blip r:embed="rId2"/>
          <a:stretch/>
        </p:blipFill>
        <p:spPr>
          <a:xfrm>
            <a:off x="0" y="122400"/>
            <a:ext cx="9144000" cy="6626160"/>
          </a:xfrm>
          <a:prstGeom prst="rect">
            <a:avLst/>
          </a:prstGeom>
          <a:ln w="0">
            <a:noFill/>
          </a:ln>
        </p:spPr>
      </p:pic>
      <p:sp>
        <p:nvSpPr>
          <p:cNvPr id="234" name=""/>
          <p:cNvSpPr/>
          <p:nvPr/>
        </p:nvSpPr>
        <p:spPr>
          <a:xfrm>
            <a:off x="1619280" y="4941720"/>
            <a:ext cx="1873080" cy="432000"/>
          </a:xfrm>
          <a:prstGeom prst="ellipse">
            <a:avLst/>
          </a:prstGeom>
          <a:noFill/>
          <a:ln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6372360" y="2205000"/>
            <a:ext cx="2546280" cy="475740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111111"/>
                </a:solidFill>
                <a:latin typeface="Tahoma"/>
              </a:rPr>
              <a:t>An Online Journal Club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111111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Users can rate and discuss medical literature, and share their thoughts on any paper instantly online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111111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 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This has the potential of improving communication amongst physicians and leading to better understanding and interpretation of medical literature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457200" y="214200"/>
            <a:ext cx="8229600" cy="12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e5ffff"/>
                </a:solidFill>
                <a:latin typeface="Tahoma"/>
                <a:ea typeface="Tahoma"/>
              </a:rPr>
              <a:t>New Initiative—</a:t>
            </a:r>
            <a:r>
              <a:rPr b="1" lang="en-US" sz="2800" spc="-1" strike="noStrike">
                <a:solidFill>
                  <a:srgbClr val="e5ffff"/>
                </a:solidFill>
                <a:latin typeface="Tahoma"/>
                <a:ea typeface="Tahoma"/>
              </a:rPr>
              <a:t>Open Access 2.0</a:t>
            </a:r>
            <a:br>
              <a:rPr sz="2800"/>
            </a:b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Interactive papers that authors can </a:t>
            </a:r>
            <a:r>
              <a:rPr b="0" i="1" lang="en-US" sz="2400" spc="-1" strike="noStrike">
                <a:solidFill>
                  <a:srgbClr val="ffffff"/>
                </a:solidFill>
                <a:latin typeface="Tahoma"/>
              </a:rPr>
              <a:t>edit after publication</a:t>
            </a: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 and more (PLoS ONE -</a:t>
            </a:r>
            <a:r>
              <a:rPr b="0" lang="en-US" sz="2400" spc="-1" strike="noStrike">
                <a:solidFill>
                  <a:srgbClr val="e5ffff"/>
                </a:solidFill>
                <a:latin typeface="Tahoma"/>
                <a:ea typeface="Tahoma"/>
              </a:rPr>
              <a:t> http://www.plosone.org/</a:t>
            </a: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)</a:t>
            </a:r>
            <a:endParaRPr b="0" lang="en-US" sz="2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237" name="Rectangle 1024" descr=""/>
          <p:cNvPicPr/>
          <p:nvPr/>
        </p:nvPicPr>
        <p:blipFill>
          <a:blip r:embed="rId2"/>
          <a:stretch/>
        </p:blipFill>
        <p:spPr>
          <a:xfrm>
            <a:off x="928800" y="1585800"/>
            <a:ext cx="7286400" cy="5272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8" name="" descr=""/>
          <p:cNvPicPr/>
          <p:nvPr/>
        </p:nvPicPr>
        <p:blipFill>
          <a:blip r:embed="rId2"/>
          <a:stretch/>
        </p:blipFill>
        <p:spPr>
          <a:xfrm>
            <a:off x="2374920" y="0"/>
            <a:ext cx="6769080" cy="6858000"/>
          </a:xfrm>
          <a:prstGeom prst="rect">
            <a:avLst/>
          </a:prstGeom>
          <a:ln w="0">
            <a:noFill/>
          </a:ln>
        </p:spPr>
      </p:pic>
      <p:pic>
        <p:nvPicPr>
          <p:cNvPr id="239" name="" descr=""/>
          <p:cNvPicPr/>
          <p:nvPr/>
        </p:nvPicPr>
        <p:blipFill>
          <a:blip r:embed="rId3"/>
          <a:stretch/>
        </p:blipFill>
        <p:spPr>
          <a:xfrm>
            <a:off x="4859280" y="6189840"/>
            <a:ext cx="1903320" cy="479160"/>
          </a:xfrm>
          <a:prstGeom prst="rect">
            <a:avLst/>
          </a:prstGeom>
          <a:ln w="0">
            <a:noFill/>
          </a:ln>
        </p:spPr>
      </p:pic>
      <p:sp>
        <p:nvSpPr>
          <p:cNvPr id="240" name=""/>
          <p:cNvSpPr/>
          <p:nvPr/>
        </p:nvSpPr>
        <p:spPr>
          <a:xfrm>
            <a:off x="179280" y="189000"/>
            <a:ext cx="2089080" cy="695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Inspired by the successful </a:t>
            </a:r>
            <a:r>
              <a:rPr b="1" lang="en-GB" sz="1800" spc="-1" strike="noStrike">
                <a:solidFill>
                  <a:srgbClr val="ffffff"/>
                </a:solidFill>
                <a:latin typeface="Tahoma"/>
              </a:rPr>
              <a:t>Yahoo! 360° model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, the resultant ‘use scenarios’ should also be designed to provide the ‘binding glue’ for the different technologies on offer (wikis, blogs/ photoblogs and podcasts/ vodcasts) and existing online medical/health information services, integrating them synergistically into </a:t>
            </a:r>
            <a:r>
              <a:rPr b="0" i="1" lang="en-GB" sz="1800" spc="-1" strike="noStrike" u="sng">
                <a:solidFill>
                  <a:srgbClr val="ffffff"/>
                </a:solidFill>
                <a:uFillTx/>
                <a:latin typeface="Tahoma"/>
              </a:rPr>
              <a:t>one coherent, whole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 and unique user experience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241" name="" descr=""/>
          <p:cNvPicPr/>
          <p:nvPr/>
        </p:nvPicPr>
        <p:blipFill>
          <a:blip r:embed="rId4"/>
          <a:stretch/>
        </p:blipFill>
        <p:spPr>
          <a:xfrm rot="16200000">
            <a:off x="5651280" y="549000"/>
            <a:ext cx="1297080" cy="129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"/>
          <p:cNvSpPr/>
          <p:nvPr/>
        </p:nvSpPr>
        <p:spPr>
          <a:xfrm>
            <a:off x="611280" y="5960160"/>
            <a:ext cx="7920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“</a:t>
            </a: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The scholar must be a solitary, modest and charitable soul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. </a:t>
            </a: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He must embrace solitude as a bride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...</a:t>
            </a: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that he may become acquainted with his thoughts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.”</a:t>
            </a:r>
            <a:br>
              <a:rPr sz="1600"/>
            </a:br>
            <a:r>
              <a:rPr b="0" lang="en-US" sz="1600" spc="-1" strike="noStrike">
                <a:solidFill>
                  <a:srgbClr val="ffffff"/>
                </a:solidFill>
                <a:latin typeface="Tahoma"/>
              </a:rPr>
              <a:t>—Ralph Waldo Emerson (1803-82) - Author, poet and philosopher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243" name="" descr=""/>
          <p:cNvPicPr/>
          <p:nvPr/>
        </p:nvPicPr>
        <p:blipFill>
          <a:blip r:embed="rId2"/>
          <a:stretch/>
        </p:blipFill>
        <p:spPr>
          <a:xfrm>
            <a:off x="863640" y="1557360"/>
            <a:ext cx="7416720" cy="3822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188640"/>
            <a:ext cx="8229600" cy="7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4000" spc="-1" strike="noStrike">
                <a:solidFill>
                  <a:srgbClr val="e5ffff"/>
                </a:solidFill>
                <a:latin typeface="Tahoma"/>
              </a:rPr>
              <a:t>Wikis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6840" y="1052280"/>
            <a:ext cx="8218440" cy="5545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7000"/>
          </a:bodyPr>
          <a:p>
            <a:pPr marL="332640" indent="-332640">
              <a:lnSpc>
                <a:spcPct val="90000"/>
              </a:lnSpc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A wiki (from Hawaiian </a:t>
            </a:r>
            <a:r>
              <a:rPr b="0" i="1" lang="en-GB" sz="2000" spc="-1" strike="noStrike">
                <a:solidFill>
                  <a:srgbClr val="ffffff"/>
                </a:solidFill>
                <a:latin typeface="Tahoma"/>
              </a:rPr>
              <a:t>wiki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, to hurry, swift) is a collaborative Web site whose content can be edited by anyone who has access to it.*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marL="332640" indent="-332640">
              <a:lnSpc>
                <a:spcPct val="90000"/>
              </a:lnSpc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Perhaps the best example of a wiki in action today is ‘Wikipedia – The Free Encyclopedia’ </a:t>
            </a:r>
            <a:r>
              <a:rPr b="0" lang="en-GB" sz="20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http://</a:t>
            </a:r>
            <a:r>
              <a:rPr b="0" lang="en-GB" sz="2000" spc="-1" strike="noStrike" u="sng">
                <a:solidFill>
                  <a:srgbClr val="00ccff"/>
                </a:solidFill>
                <a:uFillTx/>
                <a:latin typeface="Tahoma"/>
                <a:hlinkClick r:id="rId3"/>
              </a:rPr>
              <a:t>wikipedia.org</a:t>
            </a:r>
            <a:r>
              <a:rPr b="0" lang="en-GB" sz="2000" spc="-1" strike="noStrike" u="sng">
                <a:solidFill>
                  <a:srgbClr val="00ccff"/>
                </a:solidFill>
                <a:uFillTx/>
                <a:latin typeface="Tahoma"/>
                <a:hlinkClick r:id="rId4"/>
              </a:rPr>
              <a:t>/</a:t>
            </a: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.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marL="332640" indent="-332640">
              <a:lnSpc>
                <a:spcPct val="90000"/>
              </a:lnSpc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Wikis, and in particular Wikipedia, represent a promising principle that can significantly transform the Internet information age; they have grown very popular in recent months and years.**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marL="332640" indent="-332640">
              <a:lnSpc>
                <a:spcPct val="90000"/>
              </a:lnSpc>
              <a:spcBef>
                <a:spcPts val="4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ffffff"/>
                </a:solidFill>
                <a:latin typeface="Tahoma"/>
              </a:rPr>
              <a:t>Special conferences have been and are being organized to discuss this interesting Web phenomenon of wikis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; for example, </a:t>
            </a:r>
            <a:r>
              <a:rPr b="0" i="1" lang="en-GB" sz="1800" spc="-1" strike="noStrike">
                <a:solidFill>
                  <a:srgbClr val="ffffff"/>
                </a:solidFill>
                <a:latin typeface="Tahoma"/>
              </a:rPr>
              <a:t>Wikimania 2005, the First International Wikimedia Conference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, 4–8 August 2005, Frankfurt am Main, Germany </a:t>
            </a:r>
            <a:r>
              <a:rPr b="0" lang="en-GB" sz="1600" spc="-1" strike="noStrike" u="sng">
                <a:solidFill>
                  <a:srgbClr val="00ccff"/>
                </a:solidFill>
                <a:uFillTx/>
                <a:latin typeface="Tahoma"/>
                <a:hlinkClick r:id="rId5"/>
              </a:rPr>
              <a:t>http://wikimania.wikimedia.org/wiki/Main_Page</a:t>
            </a: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, 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and the ACM (Association for Computing Machinery)-sponsored </a:t>
            </a:r>
            <a:r>
              <a:rPr b="0" i="1" lang="en-GB" sz="1800" spc="-1" strike="noStrike">
                <a:solidFill>
                  <a:srgbClr val="ffffff"/>
                </a:solidFill>
                <a:latin typeface="Tahoma"/>
              </a:rPr>
              <a:t>WikiSym 2005, the 2005 International Symposium on Wikis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, 17–18 October 2005, San Diego, California, USA 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6"/>
              </a:rPr>
              <a:t>http://www.wikisym.org/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 (next 2006 event: </a:t>
            </a:r>
            <a:r>
              <a:rPr b="0" lang="en-GB" sz="1800" spc="-1" strike="noStrike" u="sng">
                <a:solidFill>
                  <a:srgbClr val="00ccff"/>
                </a:solidFill>
                <a:uFillTx/>
                <a:latin typeface="Tahoma"/>
                <a:hlinkClick r:id="rId7"/>
              </a:rPr>
              <a:t>http://www.wikisym.org/ws2006</a:t>
            </a:r>
            <a:r>
              <a:rPr b="0" lang="en-GB" sz="1800" spc="-1" strike="noStrike">
                <a:solidFill>
                  <a:srgbClr val="ffffff"/>
                </a:solidFill>
                <a:latin typeface="Tahoma"/>
              </a:rPr>
              <a:t>).</a:t>
            </a:r>
            <a:br>
              <a:rPr sz="1600"/>
            </a:br>
            <a:br>
              <a:rPr sz="1600"/>
            </a:br>
            <a:br>
              <a:rPr sz="1400"/>
            </a:b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* </a:t>
            </a:r>
            <a:r>
              <a:rPr b="0" lang="en-GB" sz="1600" spc="-1" strike="noStrike" u="sng">
                <a:solidFill>
                  <a:srgbClr val="00ccff"/>
                </a:solidFill>
                <a:uFillTx/>
                <a:latin typeface="Tahoma"/>
                <a:hlinkClick r:id="rId8"/>
              </a:rPr>
              <a:t>http://www.answers.com/topic/wiki</a:t>
            </a:r>
            <a:br>
              <a:rPr sz="1600"/>
            </a:br>
            <a:r>
              <a:rPr b="0" lang="en-GB" sz="1600" spc="-1" strike="noStrike">
                <a:solidFill>
                  <a:srgbClr val="ffffff"/>
                </a:solidFill>
                <a:latin typeface="Tahoma"/>
              </a:rPr>
              <a:t>** Connor A: Rewriting the rule books (15 August 2005) </a:t>
            </a:r>
            <a:r>
              <a:rPr b="0" lang="en-GB" sz="1600" spc="-1" strike="noStrike" u="sng">
                <a:solidFill>
                  <a:srgbClr val="00ccff"/>
                </a:solidFill>
                <a:uFillTx/>
                <a:latin typeface="Tahoma"/>
                <a:hlinkClick r:id="rId9"/>
              </a:rPr>
              <a:t>http://news.bbc.co.uk/2/hi/uk_news/magazine/4152860.stm</a:t>
            </a:r>
            <a:endParaRPr b="0" lang="en-US" sz="1600" spc="-1" strike="noStrike">
              <a:solidFill>
                <a:srgbClr val="ffffff"/>
              </a:solidFill>
              <a:latin typeface="Tahoma"/>
            </a:endParaRPr>
          </a:p>
        </p:txBody>
      </p:sp>
      <p:pic>
        <p:nvPicPr>
          <p:cNvPr id="98" name="" descr=""/>
          <p:cNvPicPr/>
          <p:nvPr/>
        </p:nvPicPr>
        <p:blipFill>
          <a:blip r:embed="rId10"/>
          <a:stretch/>
        </p:blipFill>
        <p:spPr>
          <a:xfrm>
            <a:off x="7667640" y="5300640"/>
            <a:ext cx="1353960" cy="1449360"/>
          </a:xfrm>
          <a:prstGeom prst="rect">
            <a:avLst/>
          </a:prstGeom>
          <a:ln w="9360">
            <a:solidFill>
              <a:srgbClr val="333333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" descr=""/>
          <p:cNvPicPr/>
          <p:nvPr/>
        </p:nvPicPr>
        <p:blipFill>
          <a:blip r:embed="rId2"/>
          <a:stretch/>
        </p:blipFill>
        <p:spPr>
          <a:xfrm>
            <a:off x="0" y="142920"/>
            <a:ext cx="9144000" cy="6588000"/>
          </a:xfrm>
          <a:prstGeom prst="rect">
            <a:avLst/>
          </a:prstGeom>
          <a:ln w="0">
            <a:noFill/>
          </a:ln>
        </p:spPr>
      </p:pic>
      <p:sp>
        <p:nvSpPr>
          <p:cNvPr id="100" name=""/>
          <p:cNvSpPr/>
          <p:nvPr/>
        </p:nvSpPr>
        <p:spPr>
          <a:xfrm>
            <a:off x="5359680" y="279360"/>
            <a:ext cx="37699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Wiki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744600" y="1989000"/>
            <a:ext cx="2344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111111"/>
                </a:solidFill>
                <a:latin typeface="Tahoma"/>
              </a:rPr>
              <a:t>http://ganfyd.org/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03" name=""/>
          <p:cNvSpPr/>
          <p:nvPr/>
        </p:nvSpPr>
        <p:spPr>
          <a:xfrm>
            <a:off x="5416920" y="279360"/>
            <a:ext cx="376992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Health/Medical Wiki Example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" descr=""/>
          <p:cNvPicPr/>
          <p:nvPr/>
        </p:nvPicPr>
        <p:blipFill>
          <a:blip r:embed="rId2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105" name=""/>
          <p:cNvSpPr/>
          <p:nvPr/>
        </p:nvSpPr>
        <p:spPr>
          <a:xfrm>
            <a:off x="6300720" y="2529000"/>
            <a:ext cx="2521080" cy="4115880"/>
          </a:xfrm>
          <a:prstGeom prst="rect">
            <a:avLst/>
          </a:prstGeom>
          <a:solidFill>
            <a:srgbClr val="ffff99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Wikis, blogs and podcasts all use </a:t>
            </a:r>
            <a:r>
              <a:rPr b="1" lang="en-GB" sz="1800" spc="-1" strike="noStrike">
                <a:solidFill>
                  <a:srgbClr val="111111"/>
                </a:solidFill>
                <a:latin typeface="Tahoma"/>
              </a:rPr>
              <a:t>RSS</a:t>
            </a:r>
            <a:r>
              <a:rPr b="0" lang="en-GB" sz="1800" spc="-1" strike="noStrike">
                <a:solidFill>
                  <a:srgbClr val="111111"/>
                </a:solidFill>
                <a:latin typeface="Tahoma"/>
              </a:rPr>
              <a:t>*, which is now natively supported by/built into Windows Internet Explorer 7. Users can easily set up 'feeds' to automatically receive updates from their favourite services.</a:t>
            </a:r>
            <a:br>
              <a:rPr sz="1800"/>
            </a:br>
            <a:br>
              <a:rPr sz="1600"/>
            </a:br>
            <a:r>
              <a:rPr b="0" lang="en-GB" sz="1600" spc="-1" strike="noStrike">
                <a:solidFill>
                  <a:srgbClr val="111111"/>
                </a:solidFill>
                <a:latin typeface="Tahoma"/>
              </a:rPr>
              <a:t>* RSS = Really Simple Syndication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7308720" y="260280"/>
            <a:ext cx="1511280" cy="398880"/>
          </a:xfrm>
          <a:prstGeom prst="rect">
            <a:avLst/>
          </a:prstGeom>
          <a:solidFill>
            <a:srgbClr val="2b5481">
              <a:alpha val="60000"/>
            </a:srgbClr>
          </a:solidFill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e5ffff"/>
                </a:solidFill>
                <a:latin typeface="Tahoma"/>
              </a:rPr>
              <a:t>RSS Feed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24T15:09:03Z</dcterms:created>
  <dc:creator>Dr. Maged N. Kamel Boulos</dc:creator>
  <dc:description/>
  <dc:language>en-US</dc:language>
  <cp:lastModifiedBy>Dr Maged N Kamel Boulos</cp:lastModifiedBy>
  <dcterms:modified xsi:type="dcterms:W3CDTF">2006-06-16T10:44:42Z</dcterms:modified>
  <cp:revision>107</cp:revision>
  <dc:subject/>
  <dc:title>Wikis, Blogs and Podcasts: Emerging Tools for Virtual Collaborative Practice and Learning/CPD in Medicine</dc:title>
</cp:coreProperties>
</file>